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49.png" ContentType="image/png"/>
  <Override PartName="/ppt/media/image48.png" ContentType="image/png"/>
  <Override PartName="/ppt/media/image47.png" ContentType="image/png"/>
  <Override PartName="/ppt/media/image46.png" ContentType="image/png"/>
  <Override PartName="/ppt/media/image45.png" ContentType="image/png"/>
  <Override PartName="/ppt/media/image44.png" ContentType="image/png"/>
  <Override PartName="/ppt/media/image43.png" ContentType="image/png"/>
  <Override PartName="/ppt/media/image42.png" ContentType="image/png"/>
  <Override PartName="/ppt/media/image39.png" ContentType="image/png"/>
  <Override PartName="/ppt/media/image38.png" ContentType="image/png"/>
  <Override PartName="/ppt/media/image29.png" ContentType="image/png"/>
  <Override PartName="/ppt/media/image19.png" ContentType="image/png"/>
  <Override PartName="/ppt/media/image61.png" ContentType="image/png"/>
  <Override PartName="/ppt/media/image21.png" ContentType="image/png"/>
  <Override PartName="/ppt/media/image20.png" ContentType="image/png"/>
  <Override PartName="/ppt/media/image5.wmf" ContentType="image/x-wmf"/>
  <Override PartName="/ppt/media/image17.wmf" ContentType="image/x-wmf"/>
  <Override PartName="/ppt/media/image69.png" ContentType="image/png"/>
  <Override PartName="/ppt/media/image32.png" ContentType="image/png"/>
  <Override PartName="/ppt/media/image68.png" ContentType="image/png"/>
  <Override PartName="/ppt/media/image31.png" ContentType="image/png"/>
  <Override PartName="/ppt/media/image3.wmf" ContentType="image/x-wmf"/>
  <Override PartName="/ppt/media/image58.png" ContentType="image/png"/>
  <Override PartName="/ppt/media/image15.wmf" ContentType="image/x-wmf"/>
  <Override PartName="/ppt/media/image67.png" ContentType="image/png"/>
  <Override PartName="/ppt/media/image30.png" ContentType="image/png"/>
  <Override PartName="/ppt/media/image2.wmf" ContentType="image/x-wmf"/>
  <Override PartName="/ppt/media/image57.png" ContentType="image/png"/>
  <Override PartName="/ppt/media/image14.wmf" ContentType="image/x-wmf"/>
  <Override PartName="/ppt/media/image66.png" ContentType="image/png"/>
  <Override PartName="/ppt/media/image28.png" ContentType="image/png"/>
  <Override PartName="/ppt/media/image65.png" ContentType="image/png"/>
  <Override PartName="/ppt/media/image64.png" ContentType="image/png"/>
  <Override PartName="/ppt/media/image63.png" ContentType="image/png"/>
  <Override PartName="/ppt/media/image62.png" ContentType="image/png"/>
  <Override PartName="/ppt/media/image4.wmf" ContentType="image/x-wmf"/>
  <Override PartName="/ppt/media/image16.wmf" ContentType="image/x-wmf"/>
  <Override PartName="/ppt/media/image59.png" ContentType="image/png"/>
  <Override PartName="/ppt/media/image22.png" ContentType="image/png"/>
  <Override PartName="/ppt/media/image24.png" ContentType="image/png"/>
  <Override PartName="/ppt/media/image60.png" ContentType="image/png"/>
  <Override PartName="/ppt/media/image23.png" ContentType="image/png"/>
  <Override PartName="/ppt/media/image25.png" ContentType="image/png"/>
  <Override PartName="/ppt/media/image53.png" ContentType="image/png"/>
  <Override PartName="/ppt/media/image10.wmf" ContentType="image/x-wmf"/>
  <Override PartName="/ppt/media/image18.wmf" ContentType="image/x-wmf"/>
  <Override PartName="/ppt/media/image6.wmf" ContentType="image/x-wmf"/>
  <Override PartName="/ppt/media/image26.png" ContentType="image/png"/>
  <Override PartName="/ppt/media/image54.png" ContentType="image/png"/>
  <Override PartName="/ppt/media/image11.wmf" ContentType="image/x-wmf"/>
  <Override PartName="/ppt/media/image50.png" ContentType="image/png"/>
  <Override PartName="/ppt/media/image7.wmf" ContentType="image/x-wmf"/>
  <Override PartName="/ppt/media/image27.png" ContentType="image/png"/>
  <Override PartName="/ppt/media/image55.png" ContentType="image/png"/>
  <Override PartName="/ppt/media/image12.wmf" ContentType="image/x-wmf"/>
  <Override PartName="/ppt/media/image51.png" ContentType="image/png"/>
  <Override PartName="/ppt/media/image8.wmf" ContentType="image/x-wmf"/>
  <Override PartName="/ppt/media/image40.png" ContentType="image/png"/>
  <Override PartName="/ppt/media/image56.png" ContentType="image/png"/>
  <Override PartName="/ppt/media/image1.wmf" ContentType="image/x-wmf"/>
  <Override PartName="/ppt/media/image13.wmf" ContentType="image/x-wmf"/>
  <Override PartName="/ppt/media/image52.png" ContentType="image/png"/>
  <Override PartName="/ppt/media/image9.wmf" ContentType="image/x-wmf"/>
  <Override PartName="/ppt/media/image41.png" ContentType="image/png"/>
  <Override PartName="/ppt/media/image33.png" ContentType="image/png"/>
  <Override PartName="/ppt/media/image34.png" ContentType="image/png"/>
  <Override PartName="/ppt/media/image35.png" ContentType="image/png"/>
  <Override PartName="/ppt/media/image36.png" ContentType="image/png"/>
  <Override PartName="/ppt/media/image37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12960350" cy="9359900"/>
  <p:notesSz cx="6761163" cy="99425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57905A-0314-424B-8BBD-7FF1012C0A1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90280" y="498240"/>
            <a:ext cx="11179080" cy="180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247760"/>
                <a:tab algn="l" pos="2495520"/>
                <a:tab algn="l" pos="3743280"/>
                <a:tab algn="l" pos="4991040"/>
                <a:tab algn="l" pos="6238800"/>
                <a:tab algn="l" pos="7486560"/>
                <a:tab algn="l" pos="8734320"/>
                <a:tab algn="l" pos="9982080"/>
              </a:tabLst>
            </a:pPr>
            <a:endParaRPr b="0" lang="en-US" sz="6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90280" y="2491920"/>
            <a:ext cx="11179080" cy="2832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63"/>
              </a:spcBef>
              <a:buNone/>
              <a:tabLst>
                <a:tab algn="l" pos="1247760"/>
                <a:tab algn="l" pos="2495520"/>
                <a:tab algn="l" pos="3743280"/>
                <a:tab algn="l" pos="4991040"/>
                <a:tab algn="l" pos="6238800"/>
                <a:tab algn="l" pos="7486560"/>
                <a:tab algn="l" pos="8734320"/>
                <a:tab algn="l" pos="9982080"/>
              </a:tabLst>
            </a:pPr>
            <a:endParaRPr b="0" lang="en-US" sz="3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890280" y="5593320"/>
            <a:ext cx="11179080" cy="2832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63"/>
              </a:spcBef>
              <a:buNone/>
              <a:tabLst>
                <a:tab algn="l" pos="1247760"/>
                <a:tab algn="l" pos="2495520"/>
                <a:tab algn="l" pos="3743280"/>
                <a:tab algn="l" pos="4991040"/>
                <a:tab algn="l" pos="6238800"/>
                <a:tab algn="l" pos="7486560"/>
                <a:tab algn="l" pos="8734320"/>
                <a:tab algn="l" pos="9982080"/>
              </a:tabLst>
            </a:pPr>
            <a:endParaRPr b="0" lang="en-US" sz="3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1247A0-D4E8-4EAE-A083-2BF2E32C31E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890280" y="498240"/>
            <a:ext cx="11179080" cy="180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247760"/>
                <a:tab algn="l" pos="2495520"/>
                <a:tab algn="l" pos="3743280"/>
                <a:tab algn="l" pos="4991040"/>
                <a:tab algn="l" pos="6238800"/>
                <a:tab algn="l" pos="7486560"/>
                <a:tab algn="l" pos="8734320"/>
                <a:tab algn="l" pos="9982080"/>
              </a:tabLst>
            </a:pPr>
            <a:endParaRPr b="0" lang="en-US" sz="6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890280" y="2491920"/>
            <a:ext cx="5455080" cy="2832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63"/>
              </a:spcBef>
              <a:buNone/>
              <a:tabLst>
                <a:tab algn="l" pos="1247760"/>
                <a:tab algn="l" pos="2495520"/>
                <a:tab algn="l" pos="3743280"/>
                <a:tab algn="l" pos="4991040"/>
                <a:tab algn="l" pos="6238800"/>
                <a:tab algn="l" pos="7486560"/>
                <a:tab algn="l" pos="8734320"/>
                <a:tab algn="l" pos="9982080"/>
              </a:tabLst>
            </a:pPr>
            <a:endParaRPr b="0" lang="en-US" sz="3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618600" y="2491920"/>
            <a:ext cx="5455080" cy="2832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63"/>
              </a:spcBef>
              <a:buNone/>
              <a:tabLst>
                <a:tab algn="l" pos="1247760"/>
                <a:tab algn="l" pos="2495520"/>
                <a:tab algn="l" pos="3743280"/>
                <a:tab algn="l" pos="4991040"/>
                <a:tab algn="l" pos="6238800"/>
                <a:tab algn="l" pos="7486560"/>
                <a:tab algn="l" pos="8734320"/>
                <a:tab algn="l" pos="9982080"/>
              </a:tabLst>
            </a:pPr>
            <a:endParaRPr b="0" lang="en-US" sz="3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890280" y="5593320"/>
            <a:ext cx="5455080" cy="2832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63"/>
              </a:spcBef>
              <a:buNone/>
              <a:tabLst>
                <a:tab algn="l" pos="1247760"/>
                <a:tab algn="l" pos="2495520"/>
                <a:tab algn="l" pos="3743280"/>
                <a:tab algn="l" pos="4991040"/>
                <a:tab algn="l" pos="6238800"/>
                <a:tab algn="l" pos="7486560"/>
                <a:tab algn="l" pos="8734320"/>
                <a:tab algn="l" pos="9982080"/>
              </a:tabLst>
            </a:pPr>
            <a:endParaRPr b="0" lang="en-US" sz="3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618600" y="5593320"/>
            <a:ext cx="5455080" cy="2832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63"/>
              </a:spcBef>
              <a:buNone/>
              <a:tabLst>
                <a:tab algn="l" pos="1247760"/>
                <a:tab algn="l" pos="2495520"/>
                <a:tab algn="l" pos="3743280"/>
                <a:tab algn="l" pos="4991040"/>
                <a:tab algn="l" pos="6238800"/>
                <a:tab algn="l" pos="7486560"/>
                <a:tab algn="l" pos="8734320"/>
                <a:tab algn="l" pos="9982080"/>
              </a:tabLst>
            </a:pPr>
            <a:endParaRPr b="0" lang="en-US" sz="3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62054D-EB18-489B-A51E-A248A00F11D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890280" y="498240"/>
            <a:ext cx="11179080" cy="180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247760"/>
                <a:tab algn="l" pos="2495520"/>
                <a:tab algn="l" pos="3743280"/>
                <a:tab algn="l" pos="4991040"/>
                <a:tab algn="l" pos="6238800"/>
                <a:tab algn="l" pos="7486560"/>
                <a:tab algn="l" pos="8734320"/>
                <a:tab algn="l" pos="9982080"/>
              </a:tabLst>
            </a:pPr>
            <a:endParaRPr b="0" lang="en-US" sz="6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890280" y="2491920"/>
            <a:ext cx="3599280" cy="2832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63"/>
              </a:spcBef>
              <a:buNone/>
              <a:tabLst>
                <a:tab algn="l" pos="1247760"/>
                <a:tab algn="l" pos="2495520"/>
                <a:tab algn="l" pos="3743280"/>
                <a:tab algn="l" pos="4991040"/>
                <a:tab algn="l" pos="6238800"/>
                <a:tab algn="l" pos="7486560"/>
                <a:tab algn="l" pos="8734320"/>
                <a:tab algn="l" pos="9982080"/>
              </a:tabLst>
            </a:pPr>
            <a:endParaRPr b="0" lang="en-US" sz="3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669920" y="2491920"/>
            <a:ext cx="3599280" cy="2832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63"/>
              </a:spcBef>
              <a:buNone/>
              <a:tabLst>
                <a:tab algn="l" pos="1247760"/>
                <a:tab algn="l" pos="2495520"/>
                <a:tab algn="l" pos="3743280"/>
                <a:tab algn="l" pos="4991040"/>
                <a:tab algn="l" pos="6238800"/>
                <a:tab algn="l" pos="7486560"/>
                <a:tab algn="l" pos="8734320"/>
                <a:tab algn="l" pos="9982080"/>
              </a:tabLst>
            </a:pPr>
            <a:endParaRPr b="0" lang="en-US" sz="3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8449560" y="2491920"/>
            <a:ext cx="3599280" cy="2832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63"/>
              </a:spcBef>
              <a:buNone/>
              <a:tabLst>
                <a:tab algn="l" pos="1247760"/>
                <a:tab algn="l" pos="2495520"/>
                <a:tab algn="l" pos="3743280"/>
                <a:tab algn="l" pos="4991040"/>
                <a:tab algn="l" pos="6238800"/>
                <a:tab algn="l" pos="7486560"/>
                <a:tab algn="l" pos="8734320"/>
                <a:tab algn="l" pos="9982080"/>
              </a:tabLst>
            </a:pPr>
            <a:endParaRPr b="0" lang="en-US" sz="3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890280" y="5593320"/>
            <a:ext cx="3599280" cy="2832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63"/>
              </a:spcBef>
              <a:buNone/>
              <a:tabLst>
                <a:tab algn="l" pos="1247760"/>
                <a:tab algn="l" pos="2495520"/>
                <a:tab algn="l" pos="3743280"/>
                <a:tab algn="l" pos="4991040"/>
                <a:tab algn="l" pos="6238800"/>
                <a:tab algn="l" pos="7486560"/>
                <a:tab algn="l" pos="8734320"/>
                <a:tab algn="l" pos="9982080"/>
              </a:tabLst>
            </a:pPr>
            <a:endParaRPr b="0" lang="en-US" sz="3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669920" y="5593320"/>
            <a:ext cx="3599280" cy="2832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63"/>
              </a:spcBef>
              <a:buNone/>
              <a:tabLst>
                <a:tab algn="l" pos="1247760"/>
                <a:tab algn="l" pos="2495520"/>
                <a:tab algn="l" pos="3743280"/>
                <a:tab algn="l" pos="4991040"/>
                <a:tab algn="l" pos="6238800"/>
                <a:tab algn="l" pos="7486560"/>
                <a:tab algn="l" pos="8734320"/>
                <a:tab algn="l" pos="9982080"/>
              </a:tabLst>
            </a:pPr>
            <a:endParaRPr b="0" lang="en-US" sz="3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8449560" y="5593320"/>
            <a:ext cx="3599280" cy="2832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63"/>
              </a:spcBef>
              <a:buNone/>
              <a:tabLst>
                <a:tab algn="l" pos="1247760"/>
                <a:tab algn="l" pos="2495520"/>
                <a:tab algn="l" pos="3743280"/>
                <a:tab algn="l" pos="4991040"/>
                <a:tab algn="l" pos="6238800"/>
                <a:tab algn="l" pos="7486560"/>
                <a:tab algn="l" pos="8734320"/>
                <a:tab algn="l" pos="9982080"/>
              </a:tabLst>
            </a:pPr>
            <a:endParaRPr b="0" lang="en-US" sz="3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E21D78-A5B3-43EC-AE8C-BA6E775C33F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890280" y="498240"/>
            <a:ext cx="11179080" cy="180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247760"/>
                <a:tab algn="l" pos="2495520"/>
                <a:tab algn="l" pos="3743280"/>
                <a:tab algn="l" pos="4991040"/>
                <a:tab algn="l" pos="6238800"/>
                <a:tab algn="l" pos="7486560"/>
                <a:tab algn="l" pos="8734320"/>
                <a:tab algn="l" pos="9982080"/>
              </a:tabLst>
            </a:pPr>
            <a:endParaRPr b="0" lang="en-US" sz="6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890280" y="2491920"/>
            <a:ext cx="11179080" cy="593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363"/>
              </a:spcBef>
              <a:buNone/>
              <a:tabLst>
                <a:tab algn="l" pos="0"/>
                <a:tab algn="l" pos="1247760"/>
                <a:tab algn="l" pos="2495520"/>
                <a:tab algn="l" pos="3743280"/>
                <a:tab algn="l" pos="4991040"/>
                <a:tab algn="l" pos="6238800"/>
                <a:tab algn="l" pos="7486560"/>
                <a:tab algn="l" pos="8734320"/>
                <a:tab algn="l" pos="9982080"/>
              </a:tabLst>
            </a:pPr>
            <a:endParaRPr b="0" lang="en-US" sz="3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E3EC2C-8F7C-4458-9262-DC788CE3254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890280" y="498240"/>
            <a:ext cx="11179080" cy="180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247760"/>
                <a:tab algn="l" pos="2495520"/>
                <a:tab algn="l" pos="3743280"/>
                <a:tab algn="l" pos="4991040"/>
                <a:tab algn="l" pos="6238800"/>
                <a:tab algn="l" pos="7486560"/>
                <a:tab algn="l" pos="8734320"/>
                <a:tab algn="l" pos="9982080"/>
              </a:tabLst>
            </a:pPr>
            <a:endParaRPr b="0" lang="en-US" sz="6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890280" y="2491920"/>
            <a:ext cx="11179080" cy="593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63"/>
              </a:spcBef>
              <a:buNone/>
              <a:tabLst>
                <a:tab algn="l" pos="1247760"/>
                <a:tab algn="l" pos="2495520"/>
                <a:tab algn="l" pos="3743280"/>
                <a:tab algn="l" pos="4991040"/>
                <a:tab algn="l" pos="6238800"/>
                <a:tab algn="l" pos="7486560"/>
                <a:tab algn="l" pos="8734320"/>
                <a:tab algn="l" pos="9982080"/>
              </a:tabLst>
            </a:pPr>
            <a:endParaRPr b="0" lang="en-US" sz="3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C7ED17-5D81-4E93-890C-9A3C357FE1C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90280" y="498240"/>
            <a:ext cx="11179080" cy="180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247760"/>
                <a:tab algn="l" pos="2495520"/>
                <a:tab algn="l" pos="3743280"/>
                <a:tab algn="l" pos="4991040"/>
                <a:tab algn="l" pos="6238800"/>
                <a:tab algn="l" pos="7486560"/>
                <a:tab algn="l" pos="8734320"/>
                <a:tab algn="l" pos="9982080"/>
              </a:tabLst>
            </a:pPr>
            <a:endParaRPr b="0" lang="en-US" sz="6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890280" y="2491920"/>
            <a:ext cx="5455080" cy="593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63"/>
              </a:spcBef>
              <a:buNone/>
              <a:tabLst>
                <a:tab algn="l" pos="1247760"/>
                <a:tab algn="l" pos="2495520"/>
                <a:tab algn="l" pos="3743280"/>
                <a:tab algn="l" pos="4991040"/>
                <a:tab algn="l" pos="6238800"/>
                <a:tab algn="l" pos="7486560"/>
                <a:tab algn="l" pos="8734320"/>
                <a:tab algn="l" pos="9982080"/>
              </a:tabLst>
            </a:pPr>
            <a:endParaRPr b="0" lang="en-US" sz="3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618600" y="2491920"/>
            <a:ext cx="5455080" cy="593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63"/>
              </a:spcBef>
              <a:buNone/>
              <a:tabLst>
                <a:tab algn="l" pos="1247760"/>
                <a:tab algn="l" pos="2495520"/>
                <a:tab algn="l" pos="3743280"/>
                <a:tab algn="l" pos="4991040"/>
                <a:tab algn="l" pos="6238800"/>
                <a:tab algn="l" pos="7486560"/>
                <a:tab algn="l" pos="8734320"/>
                <a:tab algn="l" pos="9982080"/>
              </a:tabLst>
            </a:pPr>
            <a:endParaRPr b="0" lang="en-US" sz="3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C3FDD8-8C4B-4ADE-AC20-8C501C3DF5B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890280" y="498240"/>
            <a:ext cx="11179080" cy="180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247760"/>
                <a:tab algn="l" pos="2495520"/>
                <a:tab algn="l" pos="3743280"/>
                <a:tab algn="l" pos="4991040"/>
                <a:tab algn="l" pos="6238800"/>
                <a:tab algn="l" pos="7486560"/>
                <a:tab algn="l" pos="8734320"/>
                <a:tab algn="l" pos="9982080"/>
              </a:tabLst>
            </a:pPr>
            <a:endParaRPr b="0" lang="en-US" sz="6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6862C2-7CD8-402A-9959-37E04A840BB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890280" y="498240"/>
            <a:ext cx="11179080" cy="8390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363"/>
              </a:spcBef>
              <a:tabLst>
                <a:tab algn="l" pos="0"/>
                <a:tab algn="l" pos="1247760"/>
                <a:tab algn="l" pos="2495520"/>
                <a:tab algn="l" pos="3743280"/>
                <a:tab algn="l" pos="4991040"/>
                <a:tab algn="l" pos="6238800"/>
                <a:tab algn="l" pos="7486560"/>
                <a:tab algn="l" pos="8734320"/>
                <a:tab algn="l" pos="9982080"/>
              </a:tabLst>
            </a:pPr>
            <a:endParaRPr b="0" lang="en-US" sz="3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0B0E87-4A07-4504-8F2B-3331B1ABDE8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890280" y="498240"/>
            <a:ext cx="11179080" cy="180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247760"/>
                <a:tab algn="l" pos="2495520"/>
                <a:tab algn="l" pos="3743280"/>
                <a:tab algn="l" pos="4991040"/>
                <a:tab algn="l" pos="6238800"/>
                <a:tab algn="l" pos="7486560"/>
                <a:tab algn="l" pos="8734320"/>
                <a:tab algn="l" pos="9982080"/>
              </a:tabLst>
            </a:pPr>
            <a:endParaRPr b="0" lang="en-US" sz="6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890280" y="2491920"/>
            <a:ext cx="5455080" cy="2832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63"/>
              </a:spcBef>
              <a:buNone/>
              <a:tabLst>
                <a:tab algn="l" pos="1247760"/>
                <a:tab algn="l" pos="2495520"/>
                <a:tab algn="l" pos="3743280"/>
                <a:tab algn="l" pos="4991040"/>
                <a:tab algn="l" pos="6238800"/>
                <a:tab algn="l" pos="7486560"/>
                <a:tab algn="l" pos="8734320"/>
                <a:tab algn="l" pos="9982080"/>
              </a:tabLst>
            </a:pPr>
            <a:endParaRPr b="0" lang="en-US" sz="3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618600" y="2491920"/>
            <a:ext cx="5455080" cy="593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63"/>
              </a:spcBef>
              <a:buNone/>
              <a:tabLst>
                <a:tab algn="l" pos="1247760"/>
                <a:tab algn="l" pos="2495520"/>
                <a:tab algn="l" pos="3743280"/>
                <a:tab algn="l" pos="4991040"/>
                <a:tab algn="l" pos="6238800"/>
                <a:tab algn="l" pos="7486560"/>
                <a:tab algn="l" pos="8734320"/>
                <a:tab algn="l" pos="9982080"/>
              </a:tabLst>
            </a:pPr>
            <a:endParaRPr b="0" lang="en-US" sz="3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890280" y="5593320"/>
            <a:ext cx="5455080" cy="2832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63"/>
              </a:spcBef>
              <a:buNone/>
              <a:tabLst>
                <a:tab algn="l" pos="1247760"/>
                <a:tab algn="l" pos="2495520"/>
                <a:tab algn="l" pos="3743280"/>
                <a:tab algn="l" pos="4991040"/>
                <a:tab algn="l" pos="6238800"/>
                <a:tab algn="l" pos="7486560"/>
                <a:tab algn="l" pos="8734320"/>
                <a:tab algn="l" pos="9982080"/>
              </a:tabLst>
            </a:pPr>
            <a:endParaRPr b="0" lang="en-US" sz="3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DBD9CE-4097-4EE6-A866-2C4729EE919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890280" y="498240"/>
            <a:ext cx="11179080" cy="180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247760"/>
                <a:tab algn="l" pos="2495520"/>
                <a:tab algn="l" pos="3743280"/>
                <a:tab algn="l" pos="4991040"/>
                <a:tab algn="l" pos="6238800"/>
                <a:tab algn="l" pos="7486560"/>
                <a:tab algn="l" pos="8734320"/>
                <a:tab algn="l" pos="9982080"/>
              </a:tabLst>
            </a:pPr>
            <a:endParaRPr b="0" lang="en-US" sz="6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890280" y="2491920"/>
            <a:ext cx="5455080" cy="593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63"/>
              </a:spcBef>
              <a:buNone/>
              <a:tabLst>
                <a:tab algn="l" pos="1247760"/>
                <a:tab algn="l" pos="2495520"/>
                <a:tab algn="l" pos="3743280"/>
                <a:tab algn="l" pos="4991040"/>
                <a:tab algn="l" pos="6238800"/>
                <a:tab algn="l" pos="7486560"/>
                <a:tab algn="l" pos="8734320"/>
                <a:tab algn="l" pos="9982080"/>
              </a:tabLst>
            </a:pPr>
            <a:endParaRPr b="0" lang="en-US" sz="3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618600" y="2491920"/>
            <a:ext cx="5455080" cy="2832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63"/>
              </a:spcBef>
              <a:buNone/>
              <a:tabLst>
                <a:tab algn="l" pos="1247760"/>
                <a:tab algn="l" pos="2495520"/>
                <a:tab algn="l" pos="3743280"/>
                <a:tab algn="l" pos="4991040"/>
                <a:tab algn="l" pos="6238800"/>
                <a:tab algn="l" pos="7486560"/>
                <a:tab algn="l" pos="8734320"/>
                <a:tab algn="l" pos="9982080"/>
              </a:tabLst>
            </a:pPr>
            <a:endParaRPr b="0" lang="en-US" sz="3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618600" y="5593320"/>
            <a:ext cx="5455080" cy="2832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63"/>
              </a:spcBef>
              <a:buNone/>
              <a:tabLst>
                <a:tab algn="l" pos="1247760"/>
                <a:tab algn="l" pos="2495520"/>
                <a:tab algn="l" pos="3743280"/>
                <a:tab algn="l" pos="4991040"/>
                <a:tab algn="l" pos="6238800"/>
                <a:tab algn="l" pos="7486560"/>
                <a:tab algn="l" pos="8734320"/>
                <a:tab algn="l" pos="9982080"/>
              </a:tabLst>
            </a:pPr>
            <a:endParaRPr b="0" lang="en-US" sz="3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62907B-184D-49B2-A111-66EFE2C43F5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890280" y="498240"/>
            <a:ext cx="11179080" cy="180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247760"/>
                <a:tab algn="l" pos="2495520"/>
                <a:tab algn="l" pos="3743280"/>
                <a:tab algn="l" pos="4991040"/>
                <a:tab algn="l" pos="6238800"/>
                <a:tab algn="l" pos="7486560"/>
                <a:tab algn="l" pos="8734320"/>
                <a:tab algn="l" pos="9982080"/>
              </a:tabLst>
            </a:pPr>
            <a:endParaRPr b="0" lang="en-US" sz="6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890280" y="2491920"/>
            <a:ext cx="5455080" cy="2832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63"/>
              </a:spcBef>
              <a:buNone/>
              <a:tabLst>
                <a:tab algn="l" pos="1247760"/>
                <a:tab algn="l" pos="2495520"/>
                <a:tab algn="l" pos="3743280"/>
                <a:tab algn="l" pos="4991040"/>
                <a:tab algn="l" pos="6238800"/>
                <a:tab algn="l" pos="7486560"/>
                <a:tab algn="l" pos="8734320"/>
                <a:tab algn="l" pos="9982080"/>
              </a:tabLst>
            </a:pPr>
            <a:endParaRPr b="0" lang="en-US" sz="3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618600" y="2491920"/>
            <a:ext cx="5455080" cy="2832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63"/>
              </a:spcBef>
              <a:buNone/>
              <a:tabLst>
                <a:tab algn="l" pos="1247760"/>
                <a:tab algn="l" pos="2495520"/>
                <a:tab algn="l" pos="3743280"/>
                <a:tab algn="l" pos="4991040"/>
                <a:tab algn="l" pos="6238800"/>
                <a:tab algn="l" pos="7486560"/>
                <a:tab algn="l" pos="8734320"/>
                <a:tab algn="l" pos="9982080"/>
              </a:tabLst>
            </a:pPr>
            <a:endParaRPr b="0" lang="en-US" sz="3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890280" y="5593320"/>
            <a:ext cx="11179080" cy="2832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63"/>
              </a:spcBef>
              <a:buNone/>
              <a:tabLst>
                <a:tab algn="l" pos="1247760"/>
                <a:tab algn="l" pos="2495520"/>
                <a:tab algn="l" pos="3743280"/>
                <a:tab algn="l" pos="4991040"/>
                <a:tab algn="l" pos="6238800"/>
                <a:tab algn="l" pos="7486560"/>
                <a:tab algn="l" pos="8734320"/>
                <a:tab algn="l" pos="9982080"/>
              </a:tabLst>
            </a:pPr>
            <a:endParaRPr b="0" lang="en-US" sz="3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203548-E0B5-4E37-A304-C265DEC9A9F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890280" y="498240"/>
            <a:ext cx="11179080" cy="180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247760"/>
                <a:tab algn="l" pos="2495520"/>
                <a:tab algn="l" pos="3743280"/>
                <a:tab algn="l" pos="4991040"/>
                <a:tab algn="l" pos="6238800"/>
                <a:tab algn="l" pos="7486560"/>
                <a:tab algn="l" pos="8734320"/>
                <a:tab algn="l" pos="9982080"/>
              </a:tabLst>
            </a:pPr>
            <a:r>
              <a:rPr b="0" lang="en-US" sz="60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6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90280" y="2491920"/>
            <a:ext cx="11179080" cy="593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11040" indent="-311040">
              <a:lnSpc>
                <a:spcPct val="90000"/>
              </a:lnSpc>
              <a:spcBef>
                <a:spcPts val="1363"/>
              </a:spcBef>
              <a:buClr>
                <a:srgbClr val="000000"/>
              </a:buClr>
              <a:buFont typeface="Arial"/>
              <a:buChar char="•"/>
              <a:tabLst>
                <a:tab algn="l" pos="1247760"/>
                <a:tab algn="l" pos="2495520"/>
                <a:tab algn="l" pos="3743280"/>
                <a:tab algn="l" pos="4991040"/>
                <a:tab algn="l" pos="6238800"/>
                <a:tab algn="l" pos="7486560"/>
                <a:tab algn="l" pos="8734320"/>
                <a:tab algn="l" pos="9982080"/>
              </a:tabLst>
            </a:pPr>
            <a:r>
              <a:rPr b="0" lang="en-US" sz="3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800" spc="-1" strike="noStrike">
              <a:solidFill>
                <a:srgbClr val="000000"/>
              </a:solidFill>
              <a:latin typeface="Calibri"/>
            </a:endParaRPr>
          </a:p>
          <a:p>
            <a:pPr lvl="1" marL="934920" indent="-311040">
              <a:lnSpc>
                <a:spcPct val="90000"/>
              </a:lnSpc>
              <a:spcBef>
                <a:spcPts val="1363"/>
              </a:spcBef>
              <a:buClr>
                <a:srgbClr val="000000"/>
              </a:buClr>
              <a:buFont typeface="Arial"/>
              <a:buChar char="•"/>
              <a:tabLst>
                <a:tab algn="l" pos="1247760"/>
                <a:tab algn="l" pos="2495520"/>
                <a:tab algn="l" pos="3743280"/>
                <a:tab algn="l" pos="4991040"/>
                <a:tab algn="l" pos="6238800"/>
                <a:tab algn="l" pos="7486560"/>
                <a:tab algn="l" pos="8734320"/>
                <a:tab algn="l" pos="9982080"/>
              </a:tabLst>
            </a:pPr>
            <a:r>
              <a:rPr b="0" lang="en-US" sz="3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800" spc="-1" strike="noStrike">
              <a:solidFill>
                <a:srgbClr val="000000"/>
              </a:solidFill>
              <a:latin typeface="Calibri"/>
            </a:endParaRPr>
          </a:p>
          <a:p>
            <a:pPr lvl="2" marL="1558800" indent="-311040">
              <a:lnSpc>
                <a:spcPct val="90000"/>
              </a:lnSpc>
              <a:spcBef>
                <a:spcPts val="1363"/>
              </a:spcBef>
              <a:buClr>
                <a:srgbClr val="000000"/>
              </a:buClr>
              <a:buFont typeface="Arial"/>
              <a:buChar char="•"/>
              <a:tabLst>
                <a:tab algn="l" pos="1247760"/>
                <a:tab algn="l" pos="2495520"/>
                <a:tab algn="l" pos="3743280"/>
                <a:tab algn="l" pos="4991040"/>
                <a:tab algn="l" pos="6238800"/>
                <a:tab algn="l" pos="7486560"/>
                <a:tab algn="l" pos="8734320"/>
                <a:tab algn="l" pos="9982080"/>
              </a:tabLst>
            </a:pPr>
            <a:r>
              <a:rPr b="0" lang="en-US" sz="3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800" spc="-1" strike="noStrike">
              <a:solidFill>
                <a:srgbClr val="000000"/>
              </a:solidFill>
              <a:latin typeface="Calibri"/>
            </a:endParaRPr>
          </a:p>
          <a:p>
            <a:pPr lvl="3" marL="2182680" indent="-311040">
              <a:lnSpc>
                <a:spcPct val="90000"/>
              </a:lnSpc>
              <a:spcBef>
                <a:spcPts val="1363"/>
              </a:spcBef>
              <a:buClr>
                <a:srgbClr val="000000"/>
              </a:buClr>
              <a:buFont typeface="Arial"/>
              <a:buChar char="•"/>
              <a:tabLst>
                <a:tab algn="l" pos="1247760"/>
                <a:tab algn="l" pos="2495520"/>
                <a:tab algn="l" pos="3743280"/>
                <a:tab algn="l" pos="4991040"/>
                <a:tab algn="l" pos="6238800"/>
                <a:tab algn="l" pos="7486560"/>
                <a:tab algn="l" pos="8734320"/>
                <a:tab algn="l" pos="9982080"/>
              </a:tabLst>
            </a:pPr>
            <a:r>
              <a:rPr b="0" lang="en-US" sz="3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800" spc="-1" strike="noStrike">
              <a:solidFill>
                <a:srgbClr val="000000"/>
              </a:solidFill>
              <a:latin typeface="Calibri"/>
            </a:endParaRPr>
          </a:p>
          <a:p>
            <a:pPr lvl="4" marL="2806560" indent="-311040">
              <a:lnSpc>
                <a:spcPct val="90000"/>
              </a:lnSpc>
              <a:spcBef>
                <a:spcPts val="1363"/>
              </a:spcBef>
              <a:buClr>
                <a:srgbClr val="000000"/>
              </a:buClr>
              <a:buFont typeface="Arial"/>
              <a:buChar char="•"/>
              <a:tabLst>
                <a:tab algn="l" pos="1247760"/>
                <a:tab algn="l" pos="2495520"/>
                <a:tab algn="l" pos="3743280"/>
                <a:tab algn="l" pos="4991040"/>
                <a:tab algn="l" pos="6238800"/>
                <a:tab algn="l" pos="7486560"/>
                <a:tab algn="l" pos="8734320"/>
                <a:tab algn="l" pos="9982080"/>
              </a:tabLst>
            </a:pPr>
            <a:r>
              <a:rPr b="0" lang="en-US" sz="3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800" spc="-1" strike="noStrike">
              <a:solidFill>
                <a:srgbClr val="000000"/>
              </a:solidFill>
              <a:latin typeface="Calibri"/>
            </a:endParaRPr>
          </a:p>
          <a:p>
            <a:pPr lvl="5" marL="2806560" indent="-311040">
              <a:lnSpc>
                <a:spcPct val="90000"/>
              </a:lnSpc>
              <a:spcBef>
                <a:spcPts val="1363"/>
              </a:spcBef>
              <a:buClr>
                <a:srgbClr val="000000"/>
              </a:buClr>
              <a:buFont typeface="Arial"/>
              <a:buChar char="•"/>
              <a:tabLst>
                <a:tab algn="l" pos="1247760"/>
                <a:tab algn="l" pos="2495520"/>
                <a:tab algn="l" pos="3743280"/>
                <a:tab algn="l" pos="4991040"/>
                <a:tab algn="l" pos="6238800"/>
                <a:tab algn="l" pos="7486560"/>
                <a:tab algn="l" pos="8734320"/>
                <a:tab algn="l" pos="9982080"/>
              </a:tabLst>
            </a:pPr>
            <a:r>
              <a:rPr b="0" lang="en-US" sz="3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800" spc="-1" strike="noStrike">
              <a:solidFill>
                <a:srgbClr val="000000"/>
              </a:solidFill>
              <a:latin typeface="Calibri"/>
            </a:endParaRPr>
          </a:p>
          <a:p>
            <a:pPr lvl="6" marL="2806560" indent="-311040">
              <a:lnSpc>
                <a:spcPct val="90000"/>
              </a:lnSpc>
              <a:spcBef>
                <a:spcPts val="1363"/>
              </a:spcBef>
              <a:buClr>
                <a:srgbClr val="000000"/>
              </a:buClr>
              <a:buFont typeface="Arial"/>
              <a:buChar char="•"/>
              <a:tabLst>
                <a:tab algn="l" pos="1247760"/>
                <a:tab algn="l" pos="2495520"/>
                <a:tab algn="l" pos="3743280"/>
                <a:tab algn="l" pos="4991040"/>
                <a:tab algn="l" pos="6238800"/>
                <a:tab algn="l" pos="7486560"/>
                <a:tab algn="l" pos="8734320"/>
                <a:tab algn="l" pos="9982080"/>
              </a:tabLst>
            </a:pPr>
            <a:r>
              <a:rPr b="0" lang="en-US" sz="3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890280" y="8675280"/>
            <a:ext cx="2916360" cy="498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1036800"/>
                <a:tab algn="l" pos="2073240"/>
                <a:tab algn="l" pos="3110040"/>
                <a:tab algn="l" pos="4146480"/>
                <a:tab algn="l" pos="5183280"/>
                <a:tab algn="l" pos="6219720"/>
                <a:tab algn="l" pos="7256520"/>
                <a:tab algn="l" pos="8292960"/>
                <a:tab algn="l" pos="9329760"/>
                <a:tab algn="l" pos="10366200"/>
              </a:tabLst>
              <a:defRPr b="0" lang="zh-CN" sz="16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1036800"/>
                <a:tab algn="l" pos="2073240"/>
                <a:tab algn="l" pos="3110040"/>
                <a:tab algn="l" pos="4146480"/>
                <a:tab algn="l" pos="5183280"/>
                <a:tab algn="l" pos="6219720"/>
                <a:tab algn="l" pos="7256520"/>
                <a:tab algn="l" pos="8292960"/>
                <a:tab algn="l" pos="9329760"/>
                <a:tab algn="l" pos="10366200"/>
              </a:tabLst>
            </a:pPr>
            <a:r>
              <a:rPr b="0" lang="zh-CN" sz="16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292280" y="8675280"/>
            <a:ext cx="4375080" cy="498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1036800"/>
                <a:tab algn="l" pos="2073240"/>
                <a:tab algn="l" pos="3110040"/>
                <a:tab algn="l" pos="4146480"/>
                <a:tab algn="l" pos="5183280"/>
                <a:tab algn="l" pos="6219720"/>
                <a:tab algn="l" pos="7256520"/>
                <a:tab algn="l" pos="8292960"/>
                <a:tab algn="l" pos="9329760"/>
                <a:tab algn="l" pos="1036620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9153000" y="8675280"/>
            <a:ext cx="2916360" cy="498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1036800"/>
                <a:tab algn="l" pos="2073240"/>
                <a:tab algn="l" pos="3110040"/>
                <a:tab algn="l" pos="4146480"/>
                <a:tab algn="l" pos="5183280"/>
                <a:tab algn="l" pos="6219720"/>
                <a:tab algn="l" pos="7256520"/>
                <a:tab algn="l" pos="8292960"/>
                <a:tab algn="l" pos="9329760"/>
                <a:tab algn="l" pos="10366200"/>
              </a:tabLst>
              <a:defRPr b="0" lang="zh-CN" sz="16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1036800"/>
                <a:tab algn="l" pos="2073240"/>
                <a:tab algn="l" pos="3110040"/>
                <a:tab algn="l" pos="4146480"/>
                <a:tab algn="l" pos="5183280"/>
                <a:tab algn="l" pos="6219720"/>
                <a:tab algn="l" pos="7256520"/>
                <a:tab algn="l" pos="8292960"/>
                <a:tab algn="l" pos="9329760"/>
                <a:tab algn="l" pos="10366200"/>
              </a:tabLst>
            </a:pPr>
            <a:fld id="{0973965A-9AB6-4F1C-86EB-18869D7CF047}" type="slidenum">
              <a:rPr b="0" lang="zh-CN" sz="16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3.wmf"/><Relationship Id="rId4" Type="http://schemas.openxmlformats.org/officeDocument/2006/relationships/image" Target="../media/image4.wmf"/><Relationship Id="rId5" Type="http://schemas.openxmlformats.org/officeDocument/2006/relationships/image" Target="../media/image5.wmf"/><Relationship Id="rId6" Type="http://schemas.openxmlformats.org/officeDocument/2006/relationships/image" Target="../media/image6.wmf"/><Relationship Id="rId7" Type="http://schemas.openxmlformats.org/officeDocument/2006/relationships/image" Target="../media/image7.wmf"/><Relationship Id="rId8" Type="http://schemas.openxmlformats.org/officeDocument/2006/relationships/image" Target="../media/image8.wmf"/><Relationship Id="rId9" Type="http://schemas.openxmlformats.org/officeDocument/2006/relationships/image" Target="../media/image9.wmf"/><Relationship Id="rId10" Type="http://schemas.openxmlformats.org/officeDocument/2006/relationships/image" Target="../media/image10.wmf"/><Relationship Id="rId11" Type="http://schemas.openxmlformats.org/officeDocument/2006/relationships/image" Target="../media/image11.wmf"/><Relationship Id="rId12" Type="http://schemas.openxmlformats.org/officeDocument/2006/relationships/image" Target="../media/image12.wmf"/><Relationship Id="rId13" Type="http://schemas.openxmlformats.org/officeDocument/2006/relationships/image" Target="../media/image1.wmf"/><Relationship Id="rId14" Type="http://schemas.openxmlformats.org/officeDocument/2006/relationships/image" Target="../media/image13.wmf"/><Relationship Id="rId15" Type="http://schemas.openxmlformats.org/officeDocument/2006/relationships/image" Target="../media/image14.wmf"/><Relationship Id="rId16" Type="http://schemas.openxmlformats.org/officeDocument/2006/relationships/image" Target="../media/image15.wmf"/><Relationship Id="rId17" Type="http://schemas.openxmlformats.org/officeDocument/2006/relationships/image" Target="../media/image16.wmf"/><Relationship Id="rId18" Type="http://schemas.openxmlformats.org/officeDocument/2006/relationships/image" Target="../media/image17.wmf"/><Relationship Id="rId19" Type="http://schemas.openxmlformats.org/officeDocument/2006/relationships/image" Target="../media/image18.wmf"/><Relationship Id="rId20" Type="http://schemas.openxmlformats.org/officeDocument/2006/relationships/image" Target="../media/image19.png"/><Relationship Id="rId21" Type="http://schemas.openxmlformats.org/officeDocument/2006/relationships/image" Target="../media/image20.png"/><Relationship Id="rId22" Type="http://schemas.openxmlformats.org/officeDocument/2006/relationships/image" Target="../media/image21.png"/><Relationship Id="rId23" Type="http://schemas.openxmlformats.org/officeDocument/2006/relationships/image" Target="../media/image22.png"/><Relationship Id="rId24" Type="http://schemas.openxmlformats.org/officeDocument/2006/relationships/image" Target="../media/image23.png"/><Relationship Id="rId25" Type="http://schemas.openxmlformats.org/officeDocument/2006/relationships/image" Target="../media/image24.png"/><Relationship Id="rId26" Type="http://schemas.openxmlformats.org/officeDocument/2006/relationships/image" Target="../media/image25.png"/><Relationship Id="rId27" Type="http://schemas.openxmlformats.org/officeDocument/2006/relationships/image" Target="../media/image26.png"/><Relationship Id="rId28" Type="http://schemas.openxmlformats.org/officeDocument/2006/relationships/image" Target="../media/image27.png"/><Relationship Id="rId29" Type="http://schemas.openxmlformats.org/officeDocument/2006/relationships/image" Target="../media/image25.png"/><Relationship Id="rId30" Type="http://schemas.openxmlformats.org/officeDocument/2006/relationships/image" Target="../media/image28.png"/><Relationship Id="rId31" Type="http://schemas.openxmlformats.org/officeDocument/2006/relationships/image" Target="../media/image29.png"/><Relationship Id="rId32" Type="http://schemas.openxmlformats.org/officeDocument/2006/relationships/image" Target="../media/image30.png"/><Relationship Id="rId33" Type="http://schemas.openxmlformats.org/officeDocument/2006/relationships/image" Target="../media/image31.png"/><Relationship Id="rId34" Type="http://schemas.openxmlformats.org/officeDocument/2006/relationships/image" Target="../media/image32.png"/><Relationship Id="rId35" Type="http://schemas.openxmlformats.org/officeDocument/2006/relationships/image" Target="../media/image33.png"/><Relationship Id="rId36" Type="http://schemas.openxmlformats.org/officeDocument/2006/relationships/image" Target="../media/image34.png"/><Relationship Id="rId37" Type="http://schemas.openxmlformats.org/officeDocument/2006/relationships/image" Target="../media/image35.png"/><Relationship Id="rId38" Type="http://schemas.openxmlformats.org/officeDocument/2006/relationships/image" Target="../media/image36.png"/><Relationship Id="rId39" Type="http://schemas.openxmlformats.org/officeDocument/2006/relationships/image" Target="../media/image30.png"/><Relationship Id="rId40" Type="http://schemas.openxmlformats.org/officeDocument/2006/relationships/image" Target="../media/image37.png"/><Relationship Id="rId41" Type="http://schemas.openxmlformats.org/officeDocument/2006/relationships/image" Target="../media/image38.png"/><Relationship Id="rId42" Type="http://schemas.openxmlformats.org/officeDocument/2006/relationships/image" Target="../media/image39.png"/><Relationship Id="rId43" Type="http://schemas.openxmlformats.org/officeDocument/2006/relationships/image" Target="../media/image40.png"/><Relationship Id="rId44" Type="http://schemas.openxmlformats.org/officeDocument/2006/relationships/image" Target="../media/image41.png"/><Relationship Id="rId45" Type="http://schemas.openxmlformats.org/officeDocument/2006/relationships/image" Target="../media/image42.png"/><Relationship Id="rId46" Type="http://schemas.openxmlformats.org/officeDocument/2006/relationships/image" Target="../media/image43.png"/><Relationship Id="rId47" Type="http://schemas.openxmlformats.org/officeDocument/2006/relationships/image" Target="../media/image44.png"/><Relationship Id="rId48" Type="http://schemas.openxmlformats.org/officeDocument/2006/relationships/image" Target="../media/image45.png"/><Relationship Id="rId49" Type="http://schemas.openxmlformats.org/officeDocument/2006/relationships/image" Target="../media/image46.png"/><Relationship Id="rId50" Type="http://schemas.openxmlformats.org/officeDocument/2006/relationships/image" Target="../media/image47.png"/><Relationship Id="rId51" Type="http://schemas.openxmlformats.org/officeDocument/2006/relationships/image" Target="../media/image43.png"/><Relationship Id="rId52" Type="http://schemas.openxmlformats.org/officeDocument/2006/relationships/image" Target="../media/image48.png"/><Relationship Id="rId53" Type="http://schemas.openxmlformats.org/officeDocument/2006/relationships/image" Target="../media/image49.png"/><Relationship Id="rId54" Type="http://schemas.openxmlformats.org/officeDocument/2006/relationships/image" Target="../media/image50.png"/><Relationship Id="rId55" Type="http://schemas.openxmlformats.org/officeDocument/2006/relationships/image" Target="../media/image51.png"/><Relationship Id="rId56" Type="http://schemas.openxmlformats.org/officeDocument/2006/relationships/image" Target="../media/image52.png"/><Relationship Id="rId57" Type="http://schemas.openxmlformats.org/officeDocument/2006/relationships/image" Target="../media/image34.png"/><Relationship Id="rId58" Type="http://schemas.openxmlformats.org/officeDocument/2006/relationships/image" Target="../media/image53.png"/><Relationship Id="rId59" Type="http://schemas.openxmlformats.org/officeDocument/2006/relationships/image" Target="../media/image54.png"/><Relationship Id="rId60" Type="http://schemas.openxmlformats.org/officeDocument/2006/relationships/image" Target="../media/image55.png"/><Relationship Id="rId61" Type="http://schemas.openxmlformats.org/officeDocument/2006/relationships/image" Target="../media/image56.png"/><Relationship Id="rId62" Type="http://schemas.openxmlformats.org/officeDocument/2006/relationships/image" Target="../media/image25.png"/><Relationship Id="rId63" Type="http://schemas.openxmlformats.org/officeDocument/2006/relationships/image" Target="../media/image57.png"/><Relationship Id="rId64" Type="http://schemas.openxmlformats.org/officeDocument/2006/relationships/image" Target="../media/image58.png"/><Relationship Id="rId65" Type="http://schemas.openxmlformats.org/officeDocument/2006/relationships/image" Target="../media/image59.png"/><Relationship Id="rId66" Type="http://schemas.openxmlformats.org/officeDocument/2006/relationships/image" Target="../media/image60.png"/><Relationship Id="rId67" Type="http://schemas.openxmlformats.org/officeDocument/2006/relationships/image" Target="../media/image34.png"/><Relationship Id="rId68" Type="http://schemas.openxmlformats.org/officeDocument/2006/relationships/image" Target="../media/image61.png"/><Relationship Id="rId69" Type="http://schemas.openxmlformats.org/officeDocument/2006/relationships/image" Target="../media/image62.png"/><Relationship Id="rId70" Type="http://schemas.openxmlformats.org/officeDocument/2006/relationships/image" Target="../media/image63.png"/><Relationship Id="rId71" Type="http://schemas.openxmlformats.org/officeDocument/2006/relationships/image" Target="../media/image64.png"/><Relationship Id="rId72" Type="http://schemas.openxmlformats.org/officeDocument/2006/relationships/image" Target="../media/image25.png"/><Relationship Id="rId73" Type="http://schemas.openxmlformats.org/officeDocument/2006/relationships/image" Target="../media/image34.png"/><Relationship Id="rId74" Type="http://schemas.openxmlformats.org/officeDocument/2006/relationships/image" Target="../media/image65.png"/><Relationship Id="rId75" Type="http://schemas.openxmlformats.org/officeDocument/2006/relationships/image" Target="../media/image66.png"/><Relationship Id="rId76" Type="http://schemas.openxmlformats.org/officeDocument/2006/relationships/image" Target="../media/image67.png"/><Relationship Id="rId77" Type="http://schemas.openxmlformats.org/officeDocument/2006/relationships/image" Target="../media/image68.png"/><Relationship Id="rId78" Type="http://schemas.openxmlformats.org/officeDocument/2006/relationships/image" Target="../media/image69.png"/><Relationship Id="rId79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文本框 4"/>
          <p:cNvSpPr/>
          <p:nvPr/>
        </p:nvSpPr>
        <p:spPr>
          <a:xfrm>
            <a:off x="552600" y="5091120"/>
            <a:ext cx="96012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036800"/>
                <a:tab algn="l" pos="2073240"/>
                <a:tab algn="l" pos="3110040"/>
                <a:tab algn="l" pos="4146480"/>
                <a:tab algn="l" pos="5183280"/>
                <a:tab algn="l" pos="6219720"/>
                <a:tab algn="l" pos="7256520"/>
                <a:tab algn="l" pos="8292960"/>
                <a:tab algn="l" pos="9329760"/>
                <a:tab algn="l" pos="1036620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文本框 5"/>
          <p:cNvSpPr/>
          <p:nvPr/>
        </p:nvSpPr>
        <p:spPr>
          <a:xfrm>
            <a:off x="584280" y="4840200"/>
            <a:ext cx="961920" cy="30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036800"/>
                <a:tab algn="l" pos="2073240"/>
                <a:tab algn="l" pos="3110040"/>
                <a:tab algn="l" pos="4146480"/>
                <a:tab algn="l" pos="5183280"/>
                <a:tab algn="l" pos="6219720"/>
                <a:tab algn="l" pos="7256520"/>
                <a:tab algn="l" pos="8292960"/>
                <a:tab algn="l" pos="9329760"/>
                <a:tab algn="l" pos="10366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H</a:t>
            </a:r>
            <a:r>
              <a:rPr b="0" lang="en-US" sz="1200" spc="-1" strike="noStrike" baseline="-25000">
                <a:solidFill>
                  <a:srgbClr val="000000"/>
                </a:solidFill>
                <a:latin typeface="Times New Roman"/>
                <a:ea typeface="Times New Roman"/>
              </a:rPr>
              <a:t>4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l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3" name="图片 7" descr=""/>
          <p:cNvPicPr/>
          <p:nvPr/>
        </p:nvPicPr>
        <p:blipFill>
          <a:blip r:embed="rId1"/>
          <a:stretch/>
        </p:blipFill>
        <p:spPr>
          <a:xfrm>
            <a:off x="1104840" y="5052960"/>
            <a:ext cx="927000" cy="919080"/>
          </a:xfrm>
          <a:prstGeom prst="rect">
            <a:avLst/>
          </a:prstGeom>
          <a:ln w="0">
            <a:noFill/>
          </a:ln>
        </p:spPr>
      </p:pic>
      <p:pic>
        <p:nvPicPr>
          <p:cNvPr id="44" name="图片 3" descr=""/>
          <p:cNvPicPr/>
          <p:nvPr/>
        </p:nvPicPr>
        <p:blipFill>
          <a:blip r:embed="rId2"/>
          <a:stretch/>
        </p:blipFill>
        <p:spPr>
          <a:xfrm>
            <a:off x="2009880" y="5060880"/>
            <a:ext cx="938160" cy="927000"/>
          </a:xfrm>
          <a:prstGeom prst="rect">
            <a:avLst/>
          </a:prstGeom>
          <a:ln w="0">
            <a:noFill/>
          </a:ln>
        </p:spPr>
      </p:pic>
      <p:pic>
        <p:nvPicPr>
          <p:cNvPr id="45" name="图片 9" descr=""/>
          <p:cNvPicPr/>
          <p:nvPr/>
        </p:nvPicPr>
        <p:blipFill>
          <a:blip r:embed="rId3"/>
          <a:stretch/>
        </p:blipFill>
        <p:spPr>
          <a:xfrm>
            <a:off x="2903400" y="5045040"/>
            <a:ext cx="960480" cy="963720"/>
          </a:xfrm>
          <a:prstGeom prst="rect">
            <a:avLst/>
          </a:prstGeom>
          <a:ln w="0">
            <a:noFill/>
          </a:ln>
        </p:spPr>
      </p:pic>
      <p:pic>
        <p:nvPicPr>
          <p:cNvPr id="46" name="图片 11" descr=""/>
          <p:cNvPicPr/>
          <p:nvPr/>
        </p:nvPicPr>
        <p:blipFill>
          <a:blip r:embed="rId4"/>
          <a:stretch/>
        </p:blipFill>
        <p:spPr>
          <a:xfrm>
            <a:off x="3819600" y="5045040"/>
            <a:ext cx="960480" cy="960480"/>
          </a:xfrm>
          <a:prstGeom prst="rect">
            <a:avLst/>
          </a:prstGeom>
          <a:ln w="0">
            <a:noFill/>
          </a:ln>
        </p:spPr>
      </p:pic>
      <p:pic>
        <p:nvPicPr>
          <p:cNvPr id="47" name="图片 13" descr=""/>
          <p:cNvPicPr/>
          <p:nvPr/>
        </p:nvPicPr>
        <p:blipFill>
          <a:blip r:embed="rId5"/>
          <a:stretch/>
        </p:blipFill>
        <p:spPr>
          <a:xfrm>
            <a:off x="4745160" y="5041800"/>
            <a:ext cx="950760" cy="951120"/>
          </a:xfrm>
          <a:prstGeom prst="rect">
            <a:avLst/>
          </a:prstGeom>
          <a:ln w="0">
            <a:noFill/>
          </a:ln>
        </p:spPr>
      </p:pic>
      <p:pic>
        <p:nvPicPr>
          <p:cNvPr id="48" name="图片 15" descr=""/>
          <p:cNvPicPr/>
          <p:nvPr/>
        </p:nvPicPr>
        <p:blipFill>
          <a:blip r:embed="rId6"/>
          <a:stretch/>
        </p:blipFill>
        <p:spPr>
          <a:xfrm>
            <a:off x="5662440" y="5038560"/>
            <a:ext cx="947880" cy="954360"/>
          </a:xfrm>
          <a:prstGeom prst="rect">
            <a:avLst/>
          </a:prstGeom>
          <a:ln w="0">
            <a:noFill/>
          </a:ln>
        </p:spPr>
      </p:pic>
      <p:sp>
        <p:nvSpPr>
          <p:cNvPr id="49" name="Text Box 5"/>
          <p:cNvSpPr/>
          <p:nvPr/>
        </p:nvSpPr>
        <p:spPr>
          <a:xfrm>
            <a:off x="965160" y="4816440"/>
            <a:ext cx="919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300"/>
              </a:spcBef>
              <a:tabLst>
                <a:tab algn="l" pos="0"/>
                <a:tab algn="l" pos="1036800"/>
                <a:tab algn="l" pos="2073240"/>
                <a:tab algn="l" pos="3110040"/>
                <a:tab algn="l" pos="4146480"/>
                <a:tab algn="l" pos="5183280"/>
                <a:tab algn="l" pos="6219720"/>
                <a:tab algn="l" pos="7256520"/>
                <a:tab algn="l" pos="8292960"/>
                <a:tab algn="l" pos="9329760"/>
                <a:tab algn="l" pos="10366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Vehicl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Text Box 7"/>
          <p:cNvSpPr/>
          <p:nvPr/>
        </p:nvSpPr>
        <p:spPr>
          <a:xfrm>
            <a:off x="2009880" y="4821120"/>
            <a:ext cx="998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1036800"/>
                <a:tab algn="l" pos="2073240"/>
                <a:tab algn="l" pos="3110040"/>
                <a:tab algn="l" pos="4146480"/>
                <a:tab algn="l" pos="5183280"/>
                <a:tab algn="l" pos="6219720"/>
                <a:tab algn="l" pos="7256520"/>
                <a:tab algn="l" pos="8292960"/>
                <a:tab algn="l" pos="9329760"/>
                <a:tab algn="l" pos="10366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.5m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Text Box 10"/>
          <p:cNvSpPr/>
          <p:nvPr/>
        </p:nvSpPr>
        <p:spPr>
          <a:xfrm>
            <a:off x="2903400" y="4821120"/>
            <a:ext cx="1014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1036800"/>
                <a:tab algn="l" pos="2073240"/>
                <a:tab algn="l" pos="3110040"/>
                <a:tab algn="l" pos="4146480"/>
                <a:tab algn="l" pos="5183280"/>
                <a:tab algn="l" pos="6219720"/>
                <a:tab algn="l" pos="7256520"/>
                <a:tab algn="l" pos="8292960"/>
                <a:tab algn="l" pos="9329760"/>
                <a:tab algn="l" pos="10366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m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Text Box 12"/>
          <p:cNvSpPr/>
          <p:nvPr/>
        </p:nvSpPr>
        <p:spPr>
          <a:xfrm>
            <a:off x="3857760" y="4821120"/>
            <a:ext cx="957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1036800"/>
                <a:tab algn="l" pos="2073240"/>
                <a:tab algn="l" pos="3110040"/>
                <a:tab algn="l" pos="4146480"/>
                <a:tab algn="l" pos="5183280"/>
                <a:tab algn="l" pos="6219720"/>
                <a:tab algn="l" pos="7256520"/>
                <a:tab algn="l" pos="8292960"/>
                <a:tab algn="l" pos="9329760"/>
                <a:tab algn="l" pos="10366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0m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Text Box 14"/>
          <p:cNvSpPr/>
          <p:nvPr/>
        </p:nvSpPr>
        <p:spPr>
          <a:xfrm>
            <a:off x="4800600" y="4821120"/>
            <a:ext cx="863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1036800"/>
                <a:tab algn="l" pos="2073240"/>
                <a:tab algn="l" pos="3110040"/>
                <a:tab algn="l" pos="4146480"/>
                <a:tab algn="l" pos="5183280"/>
                <a:tab algn="l" pos="6219720"/>
                <a:tab algn="l" pos="7256520"/>
                <a:tab algn="l" pos="8292960"/>
                <a:tab algn="l" pos="9329760"/>
                <a:tab algn="l" pos="10366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00m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Text Box 16"/>
          <p:cNvSpPr/>
          <p:nvPr/>
        </p:nvSpPr>
        <p:spPr>
          <a:xfrm>
            <a:off x="5802480" y="4821120"/>
            <a:ext cx="644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1036800"/>
                <a:tab algn="l" pos="2073240"/>
                <a:tab algn="l" pos="3110040"/>
                <a:tab algn="l" pos="4146480"/>
                <a:tab algn="l" pos="5183280"/>
                <a:tab algn="l" pos="6219720"/>
                <a:tab algn="l" pos="7256520"/>
                <a:tab algn="l" pos="8292960"/>
                <a:tab algn="l" pos="9329760"/>
                <a:tab algn="l" pos="10366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Text Box 17"/>
          <p:cNvSpPr/>
          <p:nvPr/>
        </p:nvSpPr>
        <p:spPr>
          <a:xfrm>
            <a:off x="655560" y="6246720"/>
            <a:ext cx="438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1036800"/>
                <a:tab algn="l" pos="2073240"/>
                <a:tab algn="l" pos="3110040"/>
                <a:tab algn="l" pos="4146480"/>
                <a:tab algn="l" pos="5183280"/>
                <a:tab algn="l" pos="6219720"/>
                <a:tab algn="l" pos="7256520"/>
                <a:tab algn="l" pos="8292960"/>
                <a:tab algn="l" pos="9329760"/>
                <a:tab algn="l" pos="10366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4h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Text Box 17"/>
          <p:cNvSpPr/>
          <p:nvPr/>
        </p:nvSpPr>
        <p:spPr>
          <a:xfrm>
            <a:off x="655560" y="5318280"/>
            <a:ext cx="438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1036800"/>
                <a:tab algn="l" pos="2073240"/>
                <a:tab algn="l" pos="3110040"/>
                <a:tab algn="l" pos="4146480"/>
                <a:tab algn="l" pos="5183280"/>
                <a:tab algn="l" pos="6219720"/>
                <a:tab algn="l" pos="7256520"/>
                <a:tab algn="l" pos="8292960"/>
                <a:tab algn="l" pos="9329760"/>
                <a:tab algn="l" pos="10366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6h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Text Box 10"/>
          <p:cNvSpPr/>
          <p:nvPr/>
        </p:nvSpPr>
        <p:spPr>
          <a:xfrm>
            <a:off x="392040" y="647640"/>
            <a:ext cx="1144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1036800"/>
                <a:tab algn="l" pos="2073240"/>
                <a:tab algn="l" pos="3110040"/>
                <a:tab algn="l" pos="4146480"/>
                <a:tab algn="l" pos="5183280"/>
                <a:tab algn="l" pos="6219720"/>
                <a:tab algn="l" pos="7256520"/>
                <a:tab algn="l" pos="8292960"/>
                <a:tab algn="l" pos="9329760"/>
                <a:tab algn="l" pos="10366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ynasore   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Text Box 19"/>
          <p:cNvSpPr/>
          <p:nvPr/>
        </p:nvSpPr>
        <p:spPr>
          <a:xfrm>
            <a:off x="1359000" y="647640"/>
            <a:ext cx="799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300"/>
              </a:spcBef>
              <a:tabLst>
                <a:tab algn="l" pos="0"/>
                <a:tab algn="l" pos="1036800"/>
                <a:tab algn="l" pos="2073240"/>
                <a:tab algn="l" pos="3110040"/>
                <a:tab algn="l" pos="4146480"/>
                <a:tab algn="l" pos="5183280"/>
                <a:tab algn="l" pos="6219720"/>
                <a:tab algn="l" pos="7256520"/>
                <a:tab algn="l" pos="8292960"/>
                <a:tab algn="l" pos="9329760"/>
                <a:tab algn="l" pos="10366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Vehicl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Text Box 21"/>
          <p:cNvSpPr/>
          <p:nvPr/>
        </p:nvSpPr>
        <p:spPr>
          <a:xfrm>
            <a:off x="2292480" y="647640"/>
            <a:ext cx="912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1036800"/>
                <a:tab algn="l" pos="2073240"/>
                <a:tab algn="l" pos="3110040"/>
                <a:tab algn="l" pos="4146480"/>
                <a:tab algn="l" pos="5183280"/>
                <a:tab algn="l" pos="6219720"/>
                <a:tab algn="l" pos="7256520"/>
                <a:tab algn="l" pos="8292960"/>
                <a:tab algn="l" pos="9329760"/>
                <a:tab algn="l" pos="10366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μ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Text Box 24"/>
          <p:cNvSpPr/>
          <p:nvPr/>
        </p:nvSpPr>
        <p:spPr>
          <a:xfrm>
            <a:off x="3040200" y="660240"/>
            <a:ext cx="858600" cy="554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1036800"/>
                <a:tab algn="l" pos="2073240"/>
                <a:tab algn="l" pos="3110040"/>
                <a:tab algn="l" pos="4146480"/>
                <a:tab algn="l" pos="5183280"/>
                <a:tab algn="l" pos="6219720"/>
                <a:tab algn="l" pos="7256520"/>
                <a:tab algn="l" pos="8292960"/>
                <a:tab algn="l" pos="9329760"/>
                <a:tab algn="l" pos="10366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0μ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1036800"/>
                <a:tab algn="l" pos="2073240"/>
                <a:tab algn="l" pos="3110040"/>
                <a:tab algn="l" pos="4146480"/>
                <a:tab algn="l" pos="5183280"/>
                <a:tab algn="l" pos="6219720"/>
                <a:tab algn="l" pos="7256520"/>
                <a:tab algn="l" pos="8292960"/>
                <a:tab algn="l" pos="9329760"/>
                <a:tab algn="l" pos="103662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Text Box 26"/>
          <p:cNvSpPr/>
          <p:nvPr/>
        </p:nvSpPr>
        <p:spPr>
          <a:xfrm>
            <a:off x="3753000" y="676440"/>
            <a:ext cx="1128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1036800"/>
                <a:tab algn="l" pos="2073240"/>
                <a:tab algn="l" pos="3110040"/>
                <a:tab algn="l" pos="4146480"/>
                <a:tab algn="l" pos="5183280"/>
                <a:tab algn="l" pos="6219720"/>
                <a:tab algn="l" pos="7256520"/>
                <a:tab algn="l" pos="8292960"/>
                <a:tab algn="l" pos="9329760"/>
                <a:tab algn="l" pos="10366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00μ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Text Box 28"/>
          <p:cNvSpPr/>
          <p:nvPr/>
        </p:nvSpPr>
        <p:spPr>
          <a:xfrm>
            <a:off x="4835520" y="665280"/>
            <a:ext cx="860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1036800"/>
                <a:tab algn="l" pos="2073240"/>
                <a:tab algn="l" pos="3110040"/>
                <a:tab algn="l" pos="4146480"/>
                <a:tab algn="l" pos="5183280"/>
                <a:tab algn="l" pos="6219720"/>
                <a:tab algn="l" pos="7256520"/>
                <a:tab algn="l" pos="8292960"/>
                <a:tab algn="l" pos="9329760"/>
                <a:tab algn="l" pos="10366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00μ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Text Box 30"/>
          <p:cNvSpPr/>
          <p:nvPr/>
        </p:nvSpPr>
        <p:spPr>
          <a:xfrm>
            <a:off x="5805360" y="663480"/>
            <a:ext cx="804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1036800"/>
                <a:tab algn="l" pos="2073240"/>
                <a:tab algn="l" pos="3110040"/>
                <a:tab algn="l" pos="4146480"/>
                <a:tab algn="l" pos="5183280"/>
                <a:tab algn="l" pos="6219720"/>
                <a:tab algn="l" pos="7256520"/>
                <a:tab algn="l" pos="8292960"/>
                <a:tab algn="l" pos="9329760"/>
                <a:tab algn="l" pos="10366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300μM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Text Box 17"/>
          <p:cNvSpPr/>
          <p:nvPr/>
        </p:nvSpPr>
        <p:spPr>
          <a:xfrm>
            <a:off x="766800" y="2011320"/>
            <a:ext cx="433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1036800"/>
                <a:tab algn="l" pos="2073240"/>
                <a:tab algn="l" pos="3110040"/>
                <a:tab algn="l" pos="4146480"/>
                <a:tab algn="l" pos="5183280"/>
                <a:tab algn="l" pos="6219720"/>
                <a:tab algn="l" pos="7256520"/>
                <a:tab algn="l" pos="8292960"/>
                <a:tab algn="l" pos="9329760"/>
                <a:tab algn="l" pos="10366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4h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Text Box 17"/>
          <p:cNvSpPr/>
          <p:nvPr/>
        </p:nvSpPr>
        <p:spPr>
          <a:xfrm>
            <a:off x="749160" y="1108080"/>
            <a:ext cx="43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1036800"/>
                <a:tab algn="l" pos="2073240"/>
                <a:tab algn="l" pos="3110040"/>
                <a:tab algn="l" pos="4146480"/>
                <a:tab algn="l" pos="5183280"/>
                <a:tab algn="l" pos="6219720"/>
                <a:tab algn="l" pos="7256520"/>
                <a:tab algn="l" pos="8292960"/>
                <a:tab algn="l" pos="9329760"/>
                <a:tab algn="l" pos="10366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6h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Text Box 4"/>
          <p:cNvSpPr/>
          <p:nvPr/>
        </p:nvSpPr>
        <p:spPr>
          <a:xfrm>
            <a:off x="552600" y="2644920"/>
            <a:ext cx="1114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1036800"/>
                <a:tab algn="l" pos="2073240"/>
                <a:tab algn="l" pos="3110040"/>
                <a:tab algn="l" pos="4146480"/>
                <a:tab algn="l" pos="5183280"/>
                <a:tab algn="l" pos="6219720"/>
                <a:tab algn="l" pos="7256520"/>
                <a:tab algn="l" pos="8292960"/>
                <a:tab algn="l" pos="9329760"/>
                <a:tab algn="l" pos="10366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Q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Text Box 6"/>
          <p:cNvSpPr/>
          <p:nvPr/>
        </p:nvSpPr>
        <p:spPr>
          <a:xfrm>
            <a:off x="2108160" y="2646360"/>
            <a:ext cx="768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1036800"/>
                <a:tab algn="l" pos="2073240"/>
                <a:tab algn="l" pos="3110040"/>
                <a:tab algn="l" pos="4146480"/>
                <a:tab algn="l" pos="5183280"/>
                <a:tab algn="l" pos="6219720"/>
                <a:tab algn="l" pos="7256520"/>
                <a:tab algn="l" pos="8292960"/>
                <a:tab algn="l" pos="9329760"/>
                <a:tab algn="l" pos="10366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μ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Text Box 8"/>
          <p:cNvSpPr/>
          <p:nvPr/>
        </p:nvSpPr>
        <p:spPr>
          <a:xfrm>
            <a:off x="3095640" y="2658960"/>
            <a:ext cx="642960" cy="554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1036800"/>
                <a:tab algn="l" pos="2073240"/>
                <a:tab algn="l" pos="3110040"/>
                <a:tab algn="l" pos="4146480"/>
                <a:tab algn="l" pos="5183280"/>
                <a:tab algn="l" pos="6219720"/>
                <a:tab algn="l" pos="7256520"/>
                <a:tab algn="l" pos="8292960"/>
                <a:tab algn="l" pos="9329760"/>
                <a:tab algn="l" pos="10366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0μ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1036800"/>
                <a:tab algn="l" pos="2073240"/>
                <a:tab algn="l" pos="3110040"/>
                <a:tab algn="l" pos="4146480"/>
                <a:tab algn="l" pos="5183280"/>
                <a:tab algn="l" pos="6219720"/>
                <a:tab algn="l" pos="7256520"/>
                <a:tab algn="l" pos="8292960"/>
                <a:tab algn="l" pos="9329760"/>
                <a:tab algn="l" pos="103662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Text Box 10"/>
          <p:cNvSpPr/>
          <p:nvPr/>
        </p:nvSpPr>
        <p:spPr>
          <a:xfrm>
            <a:off x="3903840" y="2657520"/>
            <a:ext cx="768240" cy="554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1036800"/>
                <a:tab algn="l" pos="2073240"/>
                <a:tab algn="l" pos="3110040"/>
                <a:tab algn="l" pos="4146480"/>
                <a:tab algn="l" pos="5183280"/>
                <a:tab algn="l" pos="6219720"/>
                <a:tab algn="l" pos="7256520"/>
                <a:tab algn="l" pos="8292960"/>
                <a:tab algn="l" pos="9329760"/>
                <a:tab algn="l" pos="10366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0μ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1036800"/>
                <a:tab algn="l" pos="2073240"/>
                <a:tab algn="l" pos="3110040"/>
                <a:tab algn="l" pos="4146480"/>
                <a:tab algn="l" pos="5183280"/>
                <a:tab algn="l" pos="6219720"/>
                <a:tab algn="l" pos="7256520"/>
                <a:tab algn="l" pos="8292960"/>
                <a:tab algn="l" pos="9329760"/>
                <a:tab algn="l" pos="103662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Text Box 12"/>
          <p:cNvSpPr/>
          <p:nvPr/>
        </p:nvSpPr>
        <p:spPr>
          <a:xfrm>
            <a:off x="4836960" y="2657520"/>
            <a:ext cx="723960" cy="554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1036800"/>
                <a:tab algn="l" pos="2073240"/>
                <a:tab algn="l" pos="3110040"/>
                <a:tab algn="l" pos="4146480"/>
                <a:tab algn="l" pos="5183280"/>
                <a:tab algn="l" pos="6219720"/>
                <a:tab algn="l" pos="7256520"/>
                <a:tab algn="l" pos="8292960"/>
                <a:tab algn="l" pos="9329760"/>
                <a:tab algn="l" pos="10366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00μ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1036800"/>
                <a:tab algn="l" pos="2073240"/>
                <a:tab algn="l" pos="3110040"/>
                <a:tab algn="l" pos="4146480"/>
                <a:tab algn="l" pos="5183280"/>
                <a:tab algn="l" pos="6219720"/>
                <a:tab algn="l" pos="7256520"/>
                <a:tab algn="l" pos="8292960"/>
                <a:tab algn="l" pos="9329760"/>
                <a:tab algn="l" pos="103662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Text Box 14"/>
          <p:cNvSpPr/>
          <p:nvPr/>
        </p:nvSpPr>
        <p:spPr>
          <a:xfrm>
            <a:off x="5780160" y="2657520"/>
            <a:ext cx="666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1036800"/>
                <a:tab algn="l" pos="2073240"/>
                <a:tab algn="l" pos="3110040"/>
                <a:tab algn="l" pos="4146480"/>
                <a:tab algn="l" pos="5183280"/>
                <a:tab algn="l" pos="6219720"/>
                <a:tab algn="l" pos="7256520"/>
                <a:tab algn="l" pos="8292960"/>
                <a:tab algn="l" pos="9329760"/>
                <a:tab algn="l" pos="10366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m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Text Box 16"/>
          <p:cNvSpPr/>
          <p:nvPr/>
        </p:nvSpPr>
        <p:spPr>
          <a:xfrm>
            <a:off x="1319040" y="2643120"/>
            <a:ext cx="714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1036800"/>
                <a:tab algn="l" pos="2073240"/>
                <a:tab algn="l" pos="3110040"/>
                <a:tab algn="l" pos="4146480"/>
                <a:tab algn="l" pos="5183280"/>
                <a:tab algn="l" pos="6219720"/>
                <a:tab algn="l" pos="7256520"/>
                <a:tab algn="l" pos="8292960"/>
                <a:tab algn="l" pos="9329760"/>
                <a:tab algn="l" pos="10366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Vehicl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Text Box 17"/>
          <p:cNvSpPr/>
          <p:nvPr/>
        </p:nvSpPr>
        <p:spPr>
          <a:xfrm>
            <a:off x="673200" y="4122720"/>
            <a:ext cx="539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1036800"/>
                <a:tab algn="l" pos="2073240"/>
                <a:tab algn="l" pos="3110040"/>
                <a:tab algn="l" pos="4146480"/>
                <a:tab algn="l" pos="5183280"/>
                <a:tab algn="l" pos="6219720"/>
                <a:tab algn="l" pos="7256520"/>
                <a:tab algn="l" pos="8292960"/>
                <a:tab algn="l" pos="9329760"/>
                <a:tab algn="l" pos="10366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4h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4" name="图片 1" descr=""/>
          <p:cNvPicPr/>
          <p:nvPr/>
        </p:nvPicPr>
        <p:blipFill>
          <a:blip r:embed="rId7"/>
          <a:stretch/>
        </p:blipFill>
        <p:spPr>
          <a:xfrm>
            <a:off x="4753080" y="2908440"/>
            <a:ext cx="938160" cy="942840"/>
          </a:xfrm>
          <a:prstGeom prst="rect">
            <a:avLst/>
          </a:prstGeom>
          <a:ln w="0">
            <a:noFill/>
          </a:ln>
        </p:spPr>
      </p:pic>
      <p:pic>
        <p:nvPicPr>
          <p:cNvPr id="75" name="图片 2" descr=""/>
          <p:cNvPicPr/>
          <p:nvPr/>
        </p:nvPicPr>
        <p:blipFill>
          <a:blip r:embed="rId8"/>
          <a:stretch/>
        </p:blipFill>
        <p:spPr>
          <a:xfrm>
            <a:off x="3830760" y="2914560"/>
            <a:ext cx="903240" cy="943200"/>
          </a:xfrm>
          <a:prstGeom prst="rect">
            <a:avLst/>
          </a:prstGeom>
          <a:ln w="0">
            <a:noFill/>
          </a:ln>
        </p:spPr>
      </p:pic>
      <p:pic>
        <p:nvPicPr>
          <p:cNvPr id="76" name="图片 3" descr=""/>
          <p:cNvPicPr/>
          <p:nvPr/>
        </p:nvPicPr>
        <p:blipFill>
          <a:blip r:embed="rId9"/>
          <a:stretch/>
        </p:blipFill>
        <p:spPr>
          <a:xfrm>
            <a:off x="2927520" y="2916360"/>
            <a:ext cx="903240" cy="941400"/>
          </a:xfrm>
          <a:prstGeom prst="rect">
            <a:avLst/>
          </a:prstGeom>
          <a:ln w="0">
            <a:noFill/>
          </a:ln>
        </p:spPr>
      </p:pic>
      <p:pic>
        <p:nvPicPr>
          <p:cNvPr id="77" name="图片 4" descr=""/>
          <p:cNvPicPr/>
          <p:nvPr/>
        </p:nvPicPr>
        <p:blipFill>
          <a:blip r:embed="rId10"/>
          <a:stretch/>
        </p:blipFill>
        <p:spPr>
          <a:xfrm>
            <a:off x="2039760" y="2914560"/>
            <a:ext cx="903600" cy="943200"/>
          </a:xfrm>
          <a:prstGeom prst="rect">
            <a:avLst/>
          </a:prstGeom>
          <a:ln w="0">
            <a:noFill/>
          </a:ln>
        </p:spPr>
      </p:pic>
      <p:pic>
        <p:nvPicPr>
          <p:cNvPr id="78" name="图片 21" descr=""/>
          <p:cNvPicPr/>
          <p:nvPr/>
        </p:nvPicPr>
        <p:blipFill>
          <a:blip r:embed="rId11"/>
          <a:stretch/>
        </p:blipFill>
        <p:spPr>
          <a:xfrm>
            <a:off x="5621400" y="2914560"/>
            <a:ext cx="954000" cy="936720"/>
          </a:xfrm>
          <a:prstGeom prst="rect">
            <a:avLst/>
          </a:prstGeom>
          <a:ln w="0">
            <a:noFill/>
          </a:ln>
        </p:spPr>
      </p:pic>
      <p:pic>
        <p:nvPicPr>
          <p:cNvPr id="79" name="图片 6" descr=""/>
          <p:cNvPicPr/>
          <p:nvPr/>
        </p:nvPicPr>
        <p:blipFill>
          <a:blip r:embed="rId12"/>
          <a:stretch/>
        </p:blipFill>
        <p:spPr>
          <a:xfrm>
            <a:off x="1133640" y="2916360"/>
            <a:ext cx="903240" cy="941400"/>
          </a:xfrm>
          <a:prstGeom prst="rect">
            <a:avLst/>
          </a:prstGeom>
          <a:ln w="0">
            <a:noFill/>
          </a:ln>
        </p:spPr>
      </p:pic>
      <p:sp>
        <p:nvSpPr>
          <p:cNvPr id="80" name="Text Box 17"/>
          <p:cNvSpPr/>
          <p:nvPr/>
        </p:nvSpPr>
        <p:spPr>
          <a:xfrm>
            <a:off x="760320" y="3157560"/>
            <a:ext cx="412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1036800"/>
                <a:tab algn="l" pos="2073240"/>
                <a:tab algn="l" pos="3110040"/>
                <a:tab algn="l" pos="4146480"/>
                <a:tab algn="l" pos="5183280"/>
                <a:tab algn="l" pos="6219720"/>
                <a:tab algn="l" pos="7256520"/>
                <a:tab algn="l" pos="8292960"/>
                <a:tab algn="l" pos="9329760"/>
                <a:tab algn="l" pos="10366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6h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Text Box 11"/>
          <p:cNvSpPr/>
          <p:nvPr/>
        </p:nvSpPr>
        <p:spPr>
          <a:xfrm>
            <a:off x="630360" y="8362800"/>
            <a:ext cx="495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1036800"/>
                <a:tab algn="l" pos="2073240"/>
                <a:tab algn="l" pos="3110040"/>
                <a:tab algn="l" pos="4146480"/>
                <a:tab algn="l" pos="5183280"/>
                <a:tab algn="l" pos="6219720"/>
                <a:tab algn="l" pos="7256520"/>
                <a:tab algn="l" pos="8292960"/>
                <a:tab algn="l" pos="9329760"/>
                <a:tab algn="l" pos="10366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4h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82" name="图片 1" descr=""/>
          <p:cNvPicPr/>
          <p:nvPr/>
        </p:nvPicPr>
        <p:blipFill>
          <a:blip r:embed="rId13"/>
          <a:stretch/>
        </p:blipFill>
        <p:spPr>
          <a:xfrm>
            <a:off x="1103400" y="7130880"/>
            <a:ext cx="880920" cy="901800"/>
          </a:xfrm>
          <a:prstGeom prst="rect">
            <a:avLst/>
          </a:prstGeom>
          <a:ln w="0">
            <a:noFill/>
          </a:ln>
        </p:spPr>
      </p:pic>
      <p:sp>
        <p:nvSpPr>
          <p:cNvPr id="83" name="Text Box 11"/>
          <p:cNvSpPr/>
          <p:nvPr/>
        </p:nvSpPr>
        <p:spPr>
          <a:xfrm>
            <a:off x="646200" y="7448400"/>
            <a:ext cx="495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1036800"/>
                <a:tab algn="l" pos="2073240"/>
                <a:tab algn="l" pos="3110040"/>
                <a:tab algn="l" pos="4146480"/>
                <a:tab algn="l" pos="5183280"/>
                <a:tab algn="l" pos="6219720"/>
                <a:tab algn="l" pos="7256520"/>
                <a:tab algn="l" pos="8292960"/>
                <a:tab algn="l" pos="9329760"/>
                <a:tab algn="l" pos="10366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6h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84" name="图片 2" descr=""/>
          <p:cNvPicPr/>
          <p:nvPr/>
        </p:nvPicPr>
        <p:blipFill>
          <a:blip r:embed="rId14"/>
          <a:stretch/>
        </p:blipFill>
        <p:spPr>
          <a:xfrm>
            <a:off x="1951200" y="7122960"/>
            <a:ext cx="966600" cy="941400"/>
          </a:xfrm>
          <a:prstGeom prst="rect">
            <a:avLst/>
          </a:prstGeom>
          <a:ln w="0">
            <a:noFill/>
          </a:ln>
        </p:spPr>
      </p:pic>
      <p:pic>
        <p:nvPicPr>
          <p:cNvPr id="85" name="图片 5" descr=""/>
          <p:cNvPicPr/>
          <p:nvPr/>
        </p:nvPicPr>
        <p:blipFill>
          <a:blip r:embed="rId15"/>
          <a:stretch/>
        </p:blipFill>
        <p:spPr>
          <a:xfrm>
            <a:off x="2889360" y="7135920"/>
            <a:ext cx="938160" cy="934920"/>
          </a:xfrm>
          <a:prstGeom prst="rect">
            <a:avLst/>
          </a:prstGeom>
          <a:ln w="0">
            <a:noFill/>
          </a:ln>
        </p:spPr>
      </p:pic>
      <p:pic>
        <p:nvPicPr>
          <p:cNvPr id="86" name="图片 3" descr=""/>
          <p:cNvPicPr/>
          <p:nvPr/>
        </p:nvPicPr>
        <p:blipFill>
          <a:blip r:embed="rId16"/>
          <a:stretch/>
        </p:blipFill>
        <p:spPr>
          <a:xfrm>
            <a:off x="3827520" y="7128000"/>
            <a:ext cx="930240" cy="919080"/>
          </a:xfrm>
          <a:prstGeom prst="rect">
            <a:avLst/>
          </a:prstGeom>
          <a:ln w="0">
            <a:noFill/>
          </a:ln>
        </p:spPr>
      </p:pic>
      <p:pic>
        <p:nvPicPr>
          <p:cNvPr id="87" name="图片 4" descr=""/>
          <p:cNvPicPr/>
          <p:nvPr/>
        </p:nvPicPr>
        <p:blipFill>
          <a:blip r:embed="rId17"/>
          <a:stretch/>
        </p:blipFill>
        <p:spPr>
          <a:xfrm>
            <a:off x="4726080" y="7130880"/>
            <a:ext cx="947520" cy="944640"/>
          </a:xfrm>
          <a:prstGeom prst="rect">
            <a:avLst/>
          </a:prstGeom>
          <a:ln w="0">
            <a:noFill/>
          </a:ln>
        </p:spPr>
      </p:pic>
      <p:pic>
        <p:nvPicPr>
          <p:cNvPr id="88" name="图片 7" descr=""/>
          <p:cNvPicPr/>
          <p:nvPr/>
        </p:nvPicPr>
        <p:blipFill>
          <a:blip r:embed="rId18"/>
          <a:stretch/>
        </p:blipFill>
        <p:spPr>
          <a:xfrm>
            <a:off x="5640480" y="7132680"/>
            <a:ext cx="982440" cy="938160"/>
          </a:xfrm>
          <a:prstGeom prst="rect">
            <a:avLst/>
          </a:prstGeom>
          <a:ln w="0">
            <a:noFill/>
          </a:ln>
        </p:spPr>
      </p:pic>
      <p:sp>
        <p:nvSpPr>
          <p:cNvPr id="89" name="Text Box 10"/>
          <p:cNvSpPr/>
          <p:nvPr/>
        </p:nvSpPr>
        <p:spPr>
          <a:xfrm>
            <a:off x="187200" y="6908760"/>
            <a:ext cx="128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1036800"/>
                <a:tab algn="l" pos="2073240"/>
                <a:tab algn="l" pos="3110040"/>
                <a:tab algn="l" pos="4146480"/>
                <a:tab algn="l" pos="5183280"/>
                <a:tab algn="l" pos="6219720"/>
                <a:tab algn="l" pos="7256520"/>
                <a:tab algn="l" pos="8292960"/>
                <a:tab algn="l" pos="9329760"/>
                <a:tab algn="l" pos="10366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PZ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" name="Text Box 8"/>
          <p:cNvSpPr/>
          <p:nvPr/>
        </p:nvSpPr>
        <p:spPr>
          <a:xfrm>
            <a:off x="1236600" y="6921360"/>
            <a:ext cx="700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300"/>
              </a:spcBef>
              <a:tabLst>
                <a:tab algn="l" pos="0"/>
                <a:tab algn="l" pos="1036800"/>
                <a:tab algn="l" pos="2073240"/>
                <a:tab algn="l" pos="3110040"/>
                <a:tab algn="l" pos="4146480"/>
                <a:tab algn="l" pos="5183280"/>
                <a:tab algn="l" pos="6219720"/>
                <a:tab algn="l" pos="7256520"/>
                <a:tab algn="l" pos="8292960"/>
                <a:tab algn="l" pos="9329760"/>
                <a:tab algn="l" pos="10366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Vehicl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" name="Text Box 9"/>
          <p:cNvSpPr/>
          <p:nvPr/>
        </p:nvSpPr>
        <p:spPr>
          <a:xfrm>
            <a:off x="2030400" y="6921360"/>
            <a:ext cx="824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1036800"/>
                <a:tab algn="l" pos="2073240"/>
                <a:tab algn="l" pos="3110040"/>
                <a:tab algn="l" pos="4146480"/>
                <a:tab algn="l" pos="5183280"/>
                <a:tab algn="l" pos="6219720"/>
                <a:tab algn="l" pos="7256520"/>
                <a:tab algn="l" pos="8292960"/>
                <a:tab algn="l" pos="9329760"/>
                <a:tab algn="l" pos="10366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25m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" name="Text Box 13"/>
          <p:cNvSpPr/>
          <p:nvPr/>
        </p:nvSpPr>
        <p:spPr>
          <a:xfrm>
            <a:off x="3002040" y="6919920"/>
            <a:ext cx="765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1036800"/>
                <a:tab algn="l" pos="2073240"/>
                <a:tab algn="l" pos="3110040"/>
                <a:tab algn="l" pos="4146480"/>
                <a:tab algn="l" pos="5183280"/>
                <a:tab algn="l" pos="6219720"/>
                <a:tab algn="l" pos="7256520"/>
                <a:tab algn="l" pos="8292960"/>
                <a:tab algn="l" pos="9329760"/>
                <a:tab algn="l" pos="10366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5m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Text Box 15"/>
          <p:cNvSpPr/>
          <p:nvPr/>
        </p:nvSpPr>
        <p:spPr>
          <a:xfrm>
            <a:off x="3887640" y="6913440"/>
            <a:ext cx="763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1036800"/>
                <a:tab algn="l" pos="2073240"/>
                <a:tab algn="l" pos="3110040"/>
                <a:tab algn="l" pos="4146480"/>
                <a:tab algn="l" pos="5183280"/>
                <a:tab algn="l" pos="6219720"/>
                <a:tab algn="l" pos="7256520"/>
                <a:tab algn="l" pos="8292960"/>
                <a:tab algn="l" pos="9329760"/>
                <a:tab algn="l" pos="10366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m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" name="Text Box 17"/>
          <p:cNvSpPr/>
          <p:nvPr/>
        </p:nvSpPr>
        <p:spPr>
          <a:xfrm>
            <a:off x="4775040" y="6916680"/>
            <a:ext cx="816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1036800"/>
                <a:tab algn="l" pos="2073240"/>
                <a:tab algn="l" pos="3110040"/>
                <a:tab algn="l" pos="4146480"/>
                <a:tab algn="l" pos="5183280"/>
                <a:tab algn="l" pos="6219720"/>
                <a:tab algn="l" pos="7256520"/>
                <a:tab algn="l" pos="8292960"/>
                <a:tab algn="l" pos="9329760"/>
                <a:tab algn="l" pos="10366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5m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5" name="Text Box 19"/>
          <p:cNvSpPr/>
          <p:nvPr/>
        </p:nvSpPr>
        <p:spPr>
          <a:xfrm>
            <a:off x="5792760" y="6921360"/>
            <a:ext cx="700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1036800"/>
                <a:tab algn="l" pos="2073240"/>
                <a:tab algn="l" pos="3110040"/>
                <a:tab algn="l" pos="4146480"/>
                <a:tab algn="l" pos="5183280"/>
                <a:tab algn="l" pos="6219720"/>
                <a:tab algn="l" pos="7256520"/>
                <a:tab algn="l" pos="8292960"/>
                <a:tab algn="l" pos="9329760"/>
                <a:tab algn="l" pos="10366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0m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6" name="Text Box 14"/>
          <p:cNvSpPr/>
          <p:nvPr/>
        </p:nvSpPr>
        <p:spPr>
          <a:xfrm>
            <a:off x="6869160" y="3181320"/>
            <a:ext cx="101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1036800"/>
                <a:tab algn="l" pos="2073240"/>
                <a:tab algn="l" pos="3110040"/>
                <a:tab algn="l" pos="4146480"/>
                <a:tab algn="l" pos="5183280"/>
                <a:tab algn="l" pos="6219720"/>
                <a:tab algn="l" pos="7256520"/>
                <a:tab algn="l" pos="8292960"/>
                <a:tab algn="l" pos="9329760"/>
                <a:tab algn="l" pos="10366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6h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7" name="Text Box 17"/>
          <p:cNvSpPr/>
          <p:nvPr/>
        </p:nvSpPr>
        <p:spPr>
          <a:xfrm>
            <a:off x="8244000" y="2670120"/>
            <a:ext cx="101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1036800"/>
                <a:tab algn="l" pos="2073240"/>
                <a:tab algn="l" pos="3110040"/>
                <a:tab algn="l" pos="4146480"/>
                <a:tab algn="l" pos="5183280"/>
                <a:tab algn="l" pos="6219720"/>
                <a:tab algn="l" pos="7256520"/>
                <a:tab algn="l" pos="8292960"/>
                <a:tab algn="l" pos="9329760"/>
                <a:tab algn="l" pos="10366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2.5μ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" name="Text Box 20"/>
          <p:cNvSpPr/>
          <p:nvPr/>
        </p:nvSpPr>
        <p:spPr>
          <a:xfrm>
            <a:off x="9199440" y="2682720"/>
            <a:ext cx="101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1036800"/>
                <a:tab algn="l" pos="2073240"/>
                <a:tab algn="l" pos="3110040"/>
                <a:tab algn="l" pos="4146480"/>
                <a:tab algn="l" pos="5183280"/>
                <a:tab algn="l" pos="6219720"/>
                <a:tab algn="l" pos="7256520"/>
                <a:tab algn="l" pos="8292960"/>
                <a:tab algn="l" pos="9329760"/>
                <a:tab algn="l" pos="10366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5μ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" name="Text Box 22"/>
          <p:cNvSpPr/>
          <p:nvPr/>
        </p:nvSpPr>
        <p:spPr>
          <a:xfrm>
            <a:off x="10129680" y="2666880"/>
            <a:ext cx="101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1036800"/>
                <a:tab algn="l" pos="2073240"/>
                <a:tab algn="l" pos="3110040"/>
                <a:tab algn="l" pos="4146480"/>
                <a:tab algn="l" pos="5183280"/>
                <a:tab algn="l" pos="6219720"/>
                <a:tab algn="l" pos="7256520"/>
                <a:tab algn="l" pos="8292960"/>
                <a:tab algn="l" pos="9329760"/>
                <a:tab algn="l" pos="10366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0μ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0" name="Text Box 24"/>
          <p:cNvSpPr/>
          <p:nvPr/>
        </p:nvSpPr>
        <p:spPr>
          <a:xfrm>
            <a:off x="11174400" y="2665440"/>
            <a:ext cx="101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1036800"/>
                <a:tab algn="l" pos="2073240"/>
                <a:tab algn="l" pos="3110040"/>
                <a:tab algn="l" pos="4146480"/>
                <a:tab algn="l" pos="5183280"/>
                <a:tab algn="l" pos="6219720"/>
                <a:tab algn="l" pos="7256520"/>
                <a:tab algn="l" pos="8292960"/>
                <a:tab algn="l" pos="9329760"/>
                <a:tab algn="l" pos="10366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00μ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1" name="Text Box 27"/>
          <p:cNvSpPr/>
          <p:nvPr/>
        </p:nvSpPr>
        <p:spPr>
          <a:xfrm>
            <a:off x="6832440" y="4108320"/>
            <a:ext cx="447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1036800"/>
                <a:tab algn="l" pos="2073240"/>
                <a:tab algn="l" pos="3110040"/>
                <a:tab algn="l" pos="4146480"/>
                <a:tab algn="l" pos="5183280"/>
                <a:tab algn="l" pos="6219720"/>
                <a:tab algn="l" pos="7256520"/>
                <a:tab algn="l" pos="8292960"/>
                <a:tab algn="l" pos="9329760"/>
                <a:tab algn="l" pos="10366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4h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2" name="Text Box 14"/>
          <p:cNvSpPr/>
          <p:nvPr/>
        </p:nvSpPr>
        <p:spPr>
          <a:xfrm>
            <a:off x="6585120" y="4818240"/>
            <a:ext cx="884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1036800"/>
                <a:tab algn="l" pos="2073240"/>
                <a:tab algn="l" pos="3110040"/>
                <a:tab algn="l" pos="4146480"/>
                <a:tab algn="l" pos="5183280"/>
                <a:tab algn="l" pos="6219720"/>
                <a:tab algn="l" pos="7256520"/>
                <a:tab algn="l" pos="8292960"/>
                <a:tab algn="l" pos="9329760"/>
                <a:tab algn="l" pos="10366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ystatin  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3" name="Text Box 15"/>
          <p:cNvSpPr/>
          <p:nvPr/>
        </p:nvSpPr>
        <p:spPr>
          <a:xfrm>
            <a:off x="6865920" y="5292720"/>
            <a:ext cx="608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1036800"/>
                <a:tab algn="l" pos="2073240"/>
                <a:tab algn="l" pos="3110040"/>
                <a:tab algn="l" pos="4146480"/>
                <a:tab algn="l" pos="5183280"/>
                <a:tab algn="l" pos="6219720"/>
                <a:tab algn="l" pos="7256520"/>
                <a:tab algn="l" pos="8292960"/>
                <a:tab algn="l" pos="9329760"/>
                <a:tab algn="l" pos="10366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6h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4" name="Text Box 18"/>
          <p:cNvSpPr/>
          <p:nvPr/>
        </p:nvSpPr>
        <p:spPr>
          <a:xfrm>
            <a:off x="8128080" y="4816440"/>
            <a:ext cx="1020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1036800"/>
                <a:tab algn="l" pos="2073240"/>
                <a:tab algn="l" pos="3110040"/>
                <a:tab algn="l" pos="4146480"/>
                <a:tab algn="l" pos="5183280"/>
                <a:tab algn="l" pos="6219720"/>
                <a:tab algn="l" pos="7256520"/>
                <a:tab algn="l" pos="8292960"/>
                <a:tab algn="l" pos="9329760"/>
                <a:tab algn="l" pos="10366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μg/mL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5" name="Text Box 20"/>
          <p:cNvSpPr/>
          <p:nvPr/>
        </p:nvSpPr>
        <p:spPr>
          <a:xfrm>
            <a:off x="8975880" y="4834080"/>
            <a:ext cx="1020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1036800"/>
                <a:tab algn="l" pos="2073240"/>
                <a:tab algn="l" pos="3110040"/>
                <a:tab algn="l" pos="4146480"/>
                <a:tab algn="l" pos="5183280"/>
                <a:tab algn="l" pos="6219720"/>
                <a:tab algn="l" pos="7256520"/>
                <a:tab algn="l" pos="8292960"/>
                <a:tab algn="l" pos="9329760"/>
                <a:tab algn="l" pos="10366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5μg/mL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6" name="Text Box 22"/>
          <p:cNvSpPr/>
          <p:nvPr/>
        </p:nvSpPr>
        <p:spPr>
          <a:xfrm>
            <a:off x="9952200" y="4826160"/>
            <a:ext cx="1022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1036800"/>
                <a:tab algn="l" pos="2073240"/>
                <a:tab algn="l" pos="3110040"/>
                <a:tab algn="l" pos="4146480"/>
                <a:tab algn="l" pos="5183280"/>
                <a:tab algn="l" pos="6219720"/>
                <a:tab algn="l" pos="7256520"/>
                <a:tab algn="l" pos="8292960"/>
                <a:tab algn="l" pos="9329760"/>
                <a:tab algn="l" pos="10366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0μg/mL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7" name="Text Box 24"/>
          <p:cNvSpPr/>
          <p:nvPr/>
        </p:nvSpPr>
        <p:spPr>
          <a:xfrm>
            <a:off x="11152080" y="4844880"/>
            <a:ext cx="1020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1036800"/>
                <a:tab algn="l" pos="2073240"/>
                <a:tab algn="l" pos="3110040"/>
                <a:tab algn="l" pos="4146480"/>
                <a:tab algn="l" pos="5183280"/>
                <a:tab algn="l" pos="6219720"/>
                <a:tab algn="l" pos="7256520"/>
                <a:tab algn="l" pos="8292960"/>
                <a:tab algn="l" pos="9329760"/>
                <a:tab algn="l" pos="10366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00μg/mL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8" name="Text Box 26"/>
          <p:cNvSpPr/>
          <p:nvPr/>
        </p:nvSpPr>
        <p:spPr>
          <a:xfrm>
            <a:off x="7182000" y="4818240"/>
            <a:ext cx="1020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1036800"/>
                <a:tab algn="l" pos="2073240"/>
                <a:tab algn="l" pos="3110040"/>
                <a:tab algn="l" pos="4146480"/>
                <a:tab algn="l" pos="5183280"/>
                <a:tab algn="l" pos="6219720"/>
                <a:tab algn="l" pos="7256520"/>
                <a:tab algn="l" pos="8292960"/>
                <a:tab algn="l" pos="9329760"/>
                <a:tab algn="l" pos="10366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Vehicl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9" name="Text Box 27"/>
          <p:cNvSpPr/>
          <p:nvPr/>
        </p:nvSpPr>
        <p:spPr>
          <a:xfrm>
            <a:off x="6823080" y="6224760"/>
            <a:ext cx="606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1036800"/>
                <a:tab algn="l" pos="2073240"/>
                <a:tab algn="l" pos="3110040"/>
                <a:tab algn="l" pos="4146480"/>
                <a:tab algn="l" pos="5183280"/>
                <a:tab algn="l" pos="6219720"/>
                <a:tab algn="l" pos="7256520"/>
                <a:tab algn="l" pos="8292960"/>
                <a:tab algn="l" pos="9329760"/>
                <a:tab algn="l" pos="10366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4h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0" name="Text Box 8"/>
          <p:cNvSpPr/>
          <p:nvPr/>
        </p:nvSpPr>
        <p:spPr>
          <a:xfrm>
            <a:off x="6531120" y="658800"/>
            <a:ext cx="880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1036800"/>
                <a:tab algn="l" pos="2073240"/>
                <a:tab algn="l" pos="3110040"/>
                <a:tab algn="l" pos="4146480"/>
                <a:tab algn="l" pos="5183280"/>
                <a:tab algn="l" pos="6219720"/>
                <a:tab algn="l" pos="7256520"/>
                <a:tab algn="l" pos="8292960"/>
                <a:tab algn="l" pos="9329760"/>
                <a:tab algn="l" pos="10366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lipin</a:t>
            </a:r>
            <a:r>
              <a:rPr b="0" lang="en-US" sz="1200" spc="-1" strike="noStrike">
                <a:solidFill>
                  <a:srgbClr val="000000"/>
                </a:solidFill>
                <a:latin typeface="宋体"/>
                <a:ea typeface="Times New Roman"/>
              </a:rPr>
              <a:t>Ⅲ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1" name="Text Box 16"/>
          <p:cNvSpPr/>
          <p:nvPr/>
        </p:nvSpPr>
        <p:spPr>
          <a:xfrm>
            <a:off x="8102520" y="668160"/>
            <a:ext cx="1023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1036800"/>
                <a:tab algn="l" pos="2073240"/>
                <a:tab algn="l" pos="3110040"/>
                <a:tab algn="l" pos="4146480"/>
                <a:tab algn="l" pos="5183280"/>
                <a:tab algn="l" pos="6219720"/>
                <a:tab algn="l" pos="7256520"/>
                <a:tab algn="l" pos="8292960"/>
                <a:tab algn="l" pos="9329760"/>
                <a:tab algn="l" pos="10366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.25μg/mL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2" name="Text Box 18"/>
          <p:cNvSpPr/>
          <p:nvPr/>
        </p:nvSpPr>
        <p:spPr>
          <a:xfrm>
            <a:off x="9026640" y="677880"/>
            <a:ext cx="1023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1036800"/>
                <a:tab algn="l" pos="2073240"/>
                <a:tab algn="l" pos="3110040"/>
                <a:tab algn="l" pos="4146480"/>
                <a:tab algn="l" pos="5183280"/>
                <a:tab algn="l" pos="6219720"/>
                <a:tab algn="l" pos="7256520"/>
                <a:tab algn="l" pos="8292960"/>
                <a:tab algn="l" pos="9329760"/>
                <a:tab algn="l" pos="10366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.5μg/mL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3" name="Text Box 20"/>
          <p:cNvSpPr/>
          <p:nvPr/>
        </p:nvSpPr>
        <p:spPr>
          <a:xfrm>
            <a:off x="10059840" y="669960"/>
            <a:ext cx="1024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1036800"/>
                <a:tab algn="l" pos="2073240"/>
                <a:tab algn="l" pos="3110040"/>
                <a:tab algn="l" pos="4146480"/>
                <a:tab algn="l" pos="5183280"/>
                <a:tab algn="l" pos="6219720"/>
                <a:tab algn="l" pos="7256520"/>
                <a:tab algn="l" pos="8292960"/>
                <a:tab algn="l" pos="9329760"/>
                <a:tab algn="l" pos="10366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μg/mL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4" name="Text Box 22"/>
          <p:cNvSpPr/>
          <p:nvPr/>
        </p:nvSpPr>
        <p:spPr>
          <a:xfrm>
            <a:off x="10968120" y="689040"/>
            <a:ext cx="1023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1036800"/>
                <a:tab algn="l" pos="2073240"/>
                <a:tab algn="l" pos="3110040"/>
                <a:tab algn="l" pos="4146480"/>
                <a:tab algn="l" pos="5183280"/>
                <a:tab algn="l" pos="6219720"/>
                <a:tab algn="l" pos="7256520"/>
                <a:tab algn="l" pos="8292960"/>
                <a:tab algn="l" pos="9329760"/>
                <a:tab algn="l" pos="10366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0μg/mL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5" name="Text Box 24"/>
          <p:cNvSpPr/>
          <p:nvPr/>
        </p:nvSpPr>
        <p:spPr>
          <a:xfrm>
            <a:off x="7323120" y="668160"/>
            <a:ext cx="1023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1036800"/>
                <a:tab algn="l" pos="2073240"/>
                <a:tab algn="l" pos="3110040"/>
                <a:tab algn="l" pos="4146480"/>
                <a:tab algn="l" pos="5183280"/>
                <a:tab algn="l" pos="6219720"/>
                <a:tab algn="l" pos="7256520"/>
                <a:tab algn="l" pos="8292960"/>
                <a:tab algn="l" pos="9329760"/>
                <a:tab algn="l" pos="10366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Vehicl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6" name="Text Box 25"/>
          <p:cNvSpPr/>
          <p:nvPr/>
        </p:nvSpPr>
        <p:spPr>
          <a:xfrm>
            <a:off x="6842160" y="919080"/>
            <a:ext cx="3873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1036800"/>
                <a:tab algn="l" pos="2073240"/>
                <a:tab algn="l" pos="3110040"/>
                <a:tab algn="l" pos="4146480"/>
                <a:tab algn="l" pos="5183280"/>
                <a:tab algn="l" pos="6219720"/>
                <a:tab algn="l" pos="7256520"/>
                <a:tab algn="l" pos="8292960"/>
                <a:tab algn="l" pos="9329760"/>
                <a:tab algn="l" pos="10366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6h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7" name="Text Box 26"/>
          <p:cNvSpPr/>
          <p:nvPr/>
        </p:nvSpPr>
        <p:spPr>
          <a:xfrm>
            <a:off x="6696000" y="1987560"/>
            <a:ext cx="577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1036800"/>
                <a:tab algn="l" pos="2073240"/>
                <a:tab algn="l" pos="3110040"/>
                <a:tab algn="l" pos="4146480"/>
                <a:tab algn="l" pos="5183280"/>
                <a:tab algn="l" pos="6219720"/>
                <a:tab algn="l" pos="7256520"/>
                <a:tab algn="l" pos="8292960"/>
                <a:tab algn="l" pos="9329760"/>
                <a:tab algn="l" pos="10366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4h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18" name="图片 1" descr=""/>
          <p:cNvPicPr/>
          <p:nvPr/>
        </p:nvPicPr>
        <p:blipFill>
          <a:blip r:embed="rId19"/>
          <a:stretch/>
        </p:blipFill>
        <p:spPr>
          <a:xfrm>
            <a:off x="10991880" y="1792440"/>
            <a:ext cx="1000080" cy="896760"/>
          </a:xfrm>
          <a:prstGeom prst="rect">
            <a:avLst/>
          </a:prstGeom>
          <a:ln w="0">
            <a:noFill/>
          </a:ln>
        </p:spPr>
      </p:pic>
      <p:sp>
        <p:nvSpPr>
          <p:cNvPr id="119" name="文本框 2"/>
          <p:cNvSpPr/>
          <p:nvPr/>
        </p:nvSpPr>
        <p:spPr>
          <a:xfrm>
            <a:off x="92880" y="34920"/>
            <a:ext cx="8527680" cy="414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036800"/>
                <a:tab algn="l" pos="2073240"/>
                <a:tab algn="l" pos="3110040"/>
                <a:tab algn="l" pos="4146480"/>
                <a:tab algn="l" pos="5183280"/>
                <a:tab algn="l" pos="6219720"/>
                <a:tab algn="l" pos="7256520"/>
                <a:tab algn="l" pos="8292960"/>
                <a:tab algn="l" pos="9329760"/>
                <a:tab algn="l" pos="10366200"/>
              </a:tabLst>
            </a:pPr>
            <a:r>
              <a:rPr b="1" lang="en-US" sz="2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upplement1 Cell Viability following Administration of Inhibitors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20" name="Picture 151" descr=""/>
          <p:cNvPicPr/>
          <p:nvPr/>
        </p:nvPicPr>
        <p:blipFill>
          <a:blip r:embed="rId20"/>
          <a:stretch/>
        </p:blipFill>
        <p:spPr>
          <a:xfrm>
            <a:off x="2111400" y="861840"/>
            <a:ext cx="900000" cy="900360"/>
          </a:xfrm>
          <a:prstGeom prst="rect">
            <a:avLst/>
          </a:prstGeom>
          <a:ln w="0">
            <a:noFill/>
          </a:ln>
        </p:spPr>
      </p:pic>
      <p:pic>
        <p:nvPicPr>
          <p:cNvPr id="121" name="Picture 157" descr=""/>
          <p:cNvPicPr/>
          <p:nvPr/>
        </p:nvPicPr>
        <p:blipFill>
          <a:blip r:embed="rId21"/>
          <a:stretch/>
        </p:blipFill>
        <p:spPr>
          <a:xfrm>
            <a:off x="1141560" y="3903840"/>
            <a:ext cx="888840" cy="900000"/>
          </a:xfrm>
          <a:prstGeom prst="rect">
            <a:avLst/>
          </a:prstGeom>
          <a:ln w="0">
            <a:noFill/>
          </a:ln>
        </p:spPr>
      </p:pic>
      <p:pic>
        <p:nvPicPr>
          <p:cNvPr id="122" name="Picture 165" descr=""/>
          <p:cNvPicPr/>
          <p:nvPr/>
        </p:nvPicPr>
        <p:blipFill>
          <a:blip r:embed="rId22"/>
          <a:stretch/>
        </p:blipFill>
        <p:spPr>
          <a:xfrm>
            <a:off x="2954160" y="6048360"/>
            <a:ext cx="900360" cy="900000"/>
          </a:xfrm>
          <a:prstGeom prst="rect">
            <a:avLst/>
          </a:prstGeom>
          <a:ln w="0">
            <a:noFill/>
          </a:ln>
        </p:spPr>
      </p:pic>
      <p:pic>
        <p:nvPicPr>
          <p:cNvPr id="123" name="Picture 166" descr=""/>
          <p:cNvPicPr/>
          <p:nvPr/>
        </p:nvPicPr>
        <p:blipFill>
          <a:blip r:embed="rId23"/>
          <a:stretch/>
        </p:blipFill>
        <p:spPr>
          <a:xfrm>
            <a:off x="2039760" y="6024600"/>
            <a:ext cx="900360" cy="900000"/>
          </a:xfrm>
          <a:prstGeom prst="rect">
            <a:avLst/>
          </a:prstGeom>
          <a:ln w="0">
            <a:noFill/>
          </a:ln>
        </p:spPr>
      </p:pic>
      <p:pic>
        <p:nvPicPr>
          <p:cNvPr id="124" name="Picture 167" descr=""/>
          <p:cNvPicPr/>
          <p:nvPr/>
        </p:nvPicPr>
        <p:blipFill>
          <a:blip r:embed="rId24"/>
          <a:stretch/>
        </p:blipFill>
        <p:spPr>
          <a:xfrm>
            <a:off x="4778280" y="6056280"/>
            <a:ext cx="947880" cy="900000"/>
          </a:xfrm>
          <a:prstGeom prst="rect">
            <a:avLst/>
          </a:prstGeom>
          <a:ln w="0">
            <a:noFill/>
          </a:ln>
        </p:spPr>
      </p:pic>
      <p:pic>
        <p:nvPicPr>
          <p:cNvPr id="125" name="Picture 168" descr=""/>
          <p:cNvPicPr/>
          <p:nvPr/>
        </p:nvPicPr>
        <p:blipFill>
          <a:blip r:embed="rId25"/>
          <a:stretch/>
        </p:blipFill>
        <p:spPr>
          <a:xfrm>
            <a:off x="3827520" y="6056280"/>
            <a:ext cx="950760" cy="900000"/>
          </a:xfrm>
          <a:prstGeom prst="rect">
            <a:avLst/>
          </a:prstGeom>
          <a:ln w="0">
            <a:noFill/>
          </a:ln>
        </p:spPr>
      </p:pic>
      <p:pic>
        <p:nvPicPr>
          <p:cNvPr id="126" name="Picture 175" descr=""/>
          <p:cNvPicPr/>
          <p:nvPr/>
        </p:nvPicPr>
        <p:blipFill>
          <a:blip r:embed="rId26"/>
          <a:stretch/>
        </p:blipFill>
        <p:spPr>
          <a:xfrm>
            <a:off x="7192800" y="898560"/>
            <a:ext cx="900360" cy="900000"/>
          </a:xfrm>
          <a:prstGeom prst="rect">
            <a:avLst/>
          </a:prstGeom>
          <a:ln w="0">
            <a:noFill/>
          </a:ln>
        </p:spPr>
      </p:pic>
      <p:pic>
        <p:nvPicPr>
          <p:cNvPr id="127" name="Picture 180" descr=""/>
          <p:cNvPicPr/>
          <p:nvPr/>
        </p:nvPicPr>
        <p:blipFill>
          <a:blip r:embed="rId27"/>
          <a:stretch/>
        </p:blipFill>
        <p:spPr>
          <a:xfrm>
            <a:off x="7207200" y="1822320"/>
            <a:ext cx="900000" cy="900360"/>
          </a:xfrm>
          <a:prstGeom prst="rect">
            <a:avLst/>
          </a:prstGeom>
          <a:ln w="0">
            <a:noFill/>
          </a:ln>
        </p:spPr>
      </p:pic>
      <p:pic>
        <p:nvPicPr>
          <p:cNvPr id="128" name="Picture 181" descr=""/>
          <p:cNvPicPr/>
          <p:nvPr/>
        </p:nvPicPr>
        <p:blipFill>
          <a:blip r:embed="rId28"/>
          <a:stretch/>
        </p:blipFill>
        <p:spPr>
          <a:xfrm>
            <a:off x="9059760" y="1817640"/>
            <a:ext cx="900360" cy="900000"/>
          </a:xfrm>
          <a:prstGeom prst="rect">
            <a:avLst/>
          </a:prstGeom>
          <a:ln w="0">
            <a:noFill/>
          </a:ln>
        </p:spPr>
      </p:pic>
      <p:pic>
        <p:nvPicPr>
          <p:cNvPr id="129" name="Picture 206" descr=""/>
          <p:cNvPicPr/>
          <p:nvPr/>
        </p:nvPicPr>
        <p:blipFill>
          <a:blip r:embed="rId29"/>
          <a:stretch/>
        </p:blipFill>
        <p:spPr>
          <a:xfrm>
            <a:off x="1173240" y="866880"/>
            <a:ext cx="900000" cy="900000"/>
          </a:xfrm>
          <a:prstGeom prst="rect">
            <a:avLst/>
          </a:prstGeom>
          <a:ln w="0">
            <a:noFill/>
          </a:ln>
        </p:spPr>
      </p:pic>
      <p:pic>
        <p:nvPicPr>
          <p:cNvPr id="130" name="Picture 207" descr=""/>
          <p:cNvPicPr/>
          <p:nvPr/>
        </p:nvPicPr>
        <p:blipFill>
          <a:blip r:embed="rId30"/>
          <a:stretch/>
        </p:blipFill>
        <p:spPr>
          <a:xfrm>
            <a:off x="2963880" y="871560"/>
            <a:ext cx="900000" cy="900000"/>
          </a:xfrm>
          <a:prstGeom prst="rect">
            <a:avLst/>
          </a:prstGeom>
          <a:ln w="0">
            <a:noFill/>
          </a:ln>
        </p:spPr>
      </p:pic>
      <p:pic>
        <p:nvPicPr>
          <p:cNvPr id="131" name="Picture 208" descr=""/>
          <p:cNvPicPr/>
          <p:nvPr/>
        </p:nvPicPr>
        <p:blipFill>
          <a:blip r:embed="rId31"/>
          <a:stretch/>
        </p:blipFill>
        <p:spPr>
          <a:xfrm>
            <a:off x="3830760" y="880920"/>
            <a:ext cx="900000" cy="900360"/>
          </a:xfrm>
          <a:prstGeom prst="rect">
            <a:avLst/>
          </a:prstGeom>
          <a:ln w="0">
            <a:noFill/>
          </a:ln>
        </p:spPr>
      </p:pic>
      <p:pic>
        <p:nvPicPr>
          <p:cNvPr id="132" name="Picture 209" descr=""/>
          <p:cNvPicPr/>
          <p:nvPr/>
        </p:nvPicPr>
        <p:blipFill>
          <a:blip r:embed="rId32"/>
          <a:stretch/>
        </p:blipFill>
        <p:spPr>
          <a:xfrm>
            <a:off x="4735440" y="890640"/>
            <a:ext cx="900360" cy="900000"/>
          </a:xfrm>
          <a:prstGeom prst="rect">
            <a:avLst/>
          </a:prstGeom>
          <a:ln w="0">
            <a:noFill/>
          </a:ln>
        </p:spPr>
      </p:pic>
      <p:pic>
        <p:nvPicPr>
          <p:cNvPr id="133" name="Picture 210" descr=""/>
          <p:cNvPicPr/>
          <p:nvPr/>
        </p:nvPicPr>
        <p:blipFill>
          <a:blip r:embed="rId33"/>
          <a:stretch/>
        </p:blipFill>
        <p:spPr>
          <a:xfrm>
            <a:off x="1168560" y="1782720"/>
            <a:ext cx="900000" cy="900000"/>
          </a:xfrm>
          <a:prstGeom prst="rect">
            <a:avLst/>
          </a:prstGeom>
          <a:ln w="0">
            <a:noFill/>
          </a:ln>
        </p:spPr>
      </p:pic>
      <p:pic>
        <p:nvPicPr>
          <p:cNvPr id="134" name="Picture 211" descr=""/>
          <p:cNvPicPr/>
          <p:nvPr/>
        </p:nvPicPr>
        <p:blipFill>
          <a:blip r:embed="rId34"/>
          <a:stretch/>
        </p:blipFill>
        <p:spPr>
          <a:xfrm>
            <a:off x="2103480" y="1803240"/>
            <a:ext cx="900000" cy="900360"/>
          </a:xfrm>
          <a:prstGeom prst="rect">
            <a:avLst/>
          </a:prstGeom>
          <a:ln w="0">
            <a:noFill/>
          </a:ln>
        </p:spPr>
      </p:pic>
      <p:pic>
        <p:nvPicPr>
          <p:cNvPr id="135" name="Picture 212" descr=""/>
          <p:cNvPicPr/>
          <p:nvPr/>
        </p:nvPicPr>
        <p:blipFill>
          <a:blip r:embed="rId35"/>
          <a:stretch/>
        </p:blipFill>
        <p:spPr>
          <a:xfrm>
            <a:off x="2959200" y="1808280"/>
            <a:ext cx="900000" cy="900000"/>
          </a:xfrm>
          <a:prstGeom prst="rect">
            <a:avLst/>
          </a:prstGeom>
          <a:ln w="0">
            <a:noFill/>
          </a:ln>
        </p:spPr>
      </p:pic>
      <p:pic>
        <p:nvPicPr>
          <p:cNvPr id="136" name="Picture 214" descr=""/>
          <p:cNvPicPr/>
          <p:nvPr/>
        </p:nvPicPr>
        <p:blipFill>
          <a:blip r:embed="rId36"/>
          <a:stretch/>
        </p:blipFill>
        <p:spPr>
          <a:xfrm>
            <a:off x="3833640" y="1822320"/>
            <a:ext cx="900360" cy="900360"/>
          </a:xfrm>
          <a:prstGeom prst="rect">
            <a:avLst/>
          </a:prstGeom>
          <a:ln w="0">
            <a:noFill/>
          </a:ln>
        </p:spPr>
      </p:pic>
      <p:pic>
        <p:nvPicPr>
          <p:cNvPr id="137" name="Picture 215" descr=""/>
          <p:cNvPicPr/>
          <p:nvPr/>
        </p:nvPicPr>
        <p:blipFill>
          <a:blip r:embed="rId37"/>
          <a:stretch/>
        </p:blipFill>
        <p:spPr>
          <a:xfrm>
            <a:off x="4730760" y="1812960"/>
            <a:ext cx="900000" cy="900000"/>
          </a:xfrm>
          <a:prstGeom prst="rect">
            <a:avLst/>
          </a:prstGeom>
          <a:ln w="0">
            <a:noFill/>
          </a:ln>
        </p:spPr>
      </p:pic>
      <p:pic>
        <p:nvPicPr>
          <p:cNvPr id="138" name="Picture 216" descr=""/>
          <p:cNvPicPr/>
          <p:nvPr/>
        </p:nvPicPr>
        <p:blipFill>
          <a:blip r:embed="rId38"/>
          <a:stretch/>
        </p:blipFill>
        <p:spPr>
          <a:xfrm>
            <a:off x="5645160" y="1811160"/>
            <a:ext cx="900000" cy="900360"/>
          </a:xfrm>
          <a:prstGeom prst="rect">
            <a:avLst/>
          </a:prstGeom>
          <a:ln w="0">
            <a:noFill/>
          </a:ln>
        </p:spPr>
      </p:pic>
      <p:pic>
        <p:nvPicPr>
          <p:cNvPr id="139" name="Picture 217" descr=""/>
          <p:cNvPicPr/>
          <p:nvPr/>
        </p:nvPicPr>
        <p:blipFill>
          <a:blip r:embed="rId39"/>
          <a:stretch/>
        </p:blipFill>
        <p:spPr>
          <a:xfrm>
            <a:off x="5640480" y="912960"/>
            <a:ext cx="900000" cy="900000"/>
          </a:xfrm>
          <a:prstGeom prst="rect">
            <a:avLst/>
          </a:prstGeom>
          <a:ln w="0">
            <a:noFill/>
          </a:ln>
        </p:spPr>
      </p:pic>
      <p:pic>
        <p:nvPicPr>
          <p:cNvPr id="140" name="Picture 218" descr=""/>
          <p:cNvPicPr/>
          <p:nvPr/>
        </p:nvPicPr>
        <p:blipFill>
          <a:blip r:embed="rId40"/>
          <a:stretch/>
        </p:blipFill>
        <p:spPr>
          <a:xfrm>
            <a:off x="2028960" y="3905280"/>
            <a:ext cx="900000" cy="900000"/>
          </a:xfrm>
          <a:prstGeom prst="rect">
            <a:avLst/>
          </a:prstGeom>
          <a:ln w="0">
            <a:noFill/>
          </a:ln>
        </p:spPr>
      </p:pic>
      <p:pic>
        <p:nvPicPr>
          <p:cNvPr id="141" name="Picture 219" descr=""/>
          <p:cNvPicPr/>
          <p:nvPr/>
        </p:nvPicPr>
        <p:blipFill>
          <a:blip r:embed="rId41"/>
          <a:stretch/>
        </p:blipFill>
        <p:spPr>
          <a:xfrm>
            <a:off x="2917800" y="3913200"/>
            <a:ext cx="900000" cy="900000"/>
          </a:xfrm>
          <a:prstGeom prst="rect">
            <a:avLst/>
          </a:prstGeom>
          <a:ln w="0">
            <a:noFill/>
          </a:ln>
        </p:spPr>
      </p:pic>
      <p:pic>
        <p:nvPicPr>
          <p:cNvPr id="142" name="Picture 220" descr=""/>
          <p:cNvPicPr/>
          <p:nvPr/>
        </p:nvPicPr>
        <p:blipFill>
          <a:blip r:embed="rId42"/>
          <a:stretch/>
        </p:blipFill>
        <p:spPr>
          <a:xfrm>
            <a:off x="3805200" y="3905280"/>
            <a:ext cx="916200" cy="915840"/>
          </a:xfrm>
          <a:prstGeom prst="rect">
            <a:avLst/>
          </a:prstGeom>
          <a:ln w="0">
            <a:noFill/>
          </a:ln>
        </p:spPr>
      </p:pic>
      <p:pic>
        <p:nvPicPr>
          <p:cNvPr id="143" name="Picture 221" descr=""/>
          <p:cNvPicPr/>
          <p:nvPr/>
        </p:nvPicPr>
        <p:blipFill>
          <a:blip r:embed="rId43"/>
          <a:stretch/>
        </p:blipFill>
        <p:spPr>
          <a:xfrm>
            <a:off x="4726080" y="3897360"/>
            <a:ext cx="927000" cy="927000"/>
          </a:xfrm>
          <a:prstGeom prst="rect">
            <a:avLst/>
          </a:prstGeom>
          <a:ln w="0">
            <a:noFill/>
          </a:ln>
        </p:spPr>
      </p:pic>
      <p:pic>
        <p:nvPicPr>
          <p:cNvPr id="144" name="Picture 222" descr=""/>
          <p:cNvPicPr/>
          <p:nvPr/>
        </p:nvPicPr>
        <p:blipFill>
          <a:blip r:embed="rId44"/>
          <a:stretch/>
        </p:blipFill>
        <p:spPr>
          <a:xfrm>
            <a:off x="5616720" y="3867120"/>
            <a:ext cx="974520" cy="973080"/>
          </a:xfrm>
          <a:prstGeom prst="rect">
            <a:avLst/>
          </a:prstGeom>
          <a:ln w="0">
            <a:noFill/>
          </a:ln>
        </p:spPr>
      </p:pic>
      <p:pic>
        <p:nvPicPr>
          <p:cNvPr id="145" name="Picture 223" descr=""/>
          <p:cNvPicPr/>
          <p:nvPr/>
        </p:nvPicPr>
        <p:blipFill>
          <a:blip r:embed="rId45"/>
          <a:stretch/>
        </p:blipFill>
        <p:spPr>
          <a:xfrm>
            <a:off x="5673600" y="6060960"/>
            <a:ext cx="932040" cy="900360"/>
          </a:xfrm>
          <a:prstGeom prst="rect">
            <a:avLst/>
          </a:prstGeom>
          <a:ln w="0">
            <a:noFill/>
          </a:ln>
        </p:spPr>
      </p:pic>
      <p:pic>
        <p:nvPicPr>
          <p:cNvPr id="146" name="Picture 224" descr=""/>
          <p:cNvPicPr/>
          <p:nvPr/>
        </p:nvPicPr>
        <p:blipFill>
          <a:blip r:embed="rId46"/>
          <a:stretch/>
        </p:blipFill>
        <p:spPr>
          <a:xfrm>
            <a:off x="1125360" y="6026040"/>
            <a:ext cx="900360" cy="900360"/>
          </a:xfrm>
          <a:prstGeom prst="rect">
            <a:avLst/>
          </a:prstGeom>
          <a:ln w="0">
            <a:noFill/>
          </a:ln>
        </p:spPr>
      </p:pic>
      <p:pic>
        <p:nvPicPr>
          <p:cNvPr id="147" name="Picture 226" descr=""/>
          <p:cNvPicPr/>
          <p:nvPr/>
        </p:nvPicPr>
        <p:blipFill>
          <a:blip r:embed="rId47"/>
          <a:stretch/>
        </p:blipFill>
        <p:spPr>
          <a:xfrm>
            <a:off x="4751280" y="8136000"/>
            <a:ext cx="936720" cy="917640"/>
          </a:xfrm>
          <a:prstGeom prst="rect">
            <a:avLst/>
          </a:prstGeom>
          <a:ln w="0">
            <a:noFill/>
          </a:ln>
        </p:spPr>
      </p:pic>
      <p:pic>
        <p:nvPicPr>
          <p:cNvPr id="148" name="Picture 227" descr=""/>
          <p:cNvPicPr/>
          <p:nvPr/>
        </p:nvPicPr>
        <p:blipFill>
          <a:blip r:embed="rId48"/>
          <a:stretch/>
        </p:blipFill>
        <p:spPr>
          <a:xfrm>
            <a:off x="3833640" y="8131320"/>
            <a:ext cx="936720" cy="936360"/>
          </a:xfrm>
          <a:prstGeom prst="rect">
            <a:avLst/>
          </a:prstGeom>
          <a:ln w="0">
            <a:noFill/>
          </a:ln>
        </p:spPr>
      </p:pic>
      <p:pic>
        <p:nvPicPr>
          <p:cNvPr id="149" name="Picture 228" descr=""/>
          <p:cNvPicPr/>
          <p:nvPr/>
        </p:nvPicPr>
        <p:blipFill>
          <a:blip r:embed="rId49"/>
          <a:stretch/>
        </p:blipFill>
        <p:spPr>
          <a:xfrm>
            <a:off x="2905200" y="8145360"/>
            <a:ext cx="900000" cy="900360"/>
          </a:xfrm>
          <a:prstGeom prst="rect">
            <a:avLst/>
          </a:prstGeom>
          <a:ln w="0">
            <a:noFill/>
          </a:ln>
        </p:spPr>
      </p:pic>
      <p:pic>
        <p:nvPicPr>
          <p:cNvPr id="150" name="Picture 229" descr=""/>
          <p:cNvPicPr/>
          <p:nvPr/>
        </p:nvPicPr>
        <p:blipFill>
          <a:blip r:embed="rId50"/>
          <a:stretch/>
        </p:blipFill>
        <p:spPr>
          <a:xfrm>
            <a:off x="1981080" y="8131320"/>
            <a:ext cx="900360" cy="900000"/>
          </a:xfrm>
          <a:prstGeom prst="rect">
            <a:avLst/>
          </a:prstGeom>
          <a:ln w="0">
            <a:noFill/>
          </a:ln>
        </p:spPr>
      </p:pic>
      <p:pic>
        <p:nvPicPr>
          <p:cNvPr id="151" name="Picture 231" descr=""/>
          <p:cNvPicPr/>
          <p:nvPr/>
        </p:nvPicPr>
        <p:blipFill>
          <a:blip r:embed="rId51"/>
          <a:stretch/>
        </p:blipFill>
        <p:spPr>
          <a:xfrm>
            <a:off x="1077840" y="8120160"/>
            <a:ext cx="900360" cy="900000"/>
          </a:xfrm>
          <a:prstGeom prst="rect">
            <a:avLst/>
          </a:prstGeom>
          <a:ln w="0">
            <a:noFill/>
          </a:ln>
        </p:spPr>
      </p:pic>
      <p:pic>
        <p:nvPicPr>
          <p:cNvPr id="152" name="Picture 232" descr=""/>
          <p:cNvPicPr/>
          <p:nvPr/>
        </p:nvPicPr>
        <p:blipFill>
          <a:blip r:embed="rId52"/>
          <a:stretch/>
        </p:blipFill>
        <p:spPr>
          <a:xfrm>
            <a:off x="9102600" y="900000"/>
            <a:ext cx="900360" cy="900360"/>
          </a:xfrm>
          <a:prstGeom prst="rect">
            <a:avLst/>
          </a:prstGeom>
          <a:ln w="0">
            <a:noFill/>
          </a:ln>
        </p:spPr>
      </p:pic>
      <p:pic>
        <p:nvPicPr>
          <p:cNvPr id="153" name="Picture 233" descr=""/>
          <p:cNvPicPr/>
          <p:nvPr/>
        </p:nvPicPr>
        <p:blipFill>
          <a:blip r:embed="rId53"/>
          <a:stretch/>
        </p:blipFill>
        <p:spPr>
          <a:xfrm>
            <a:off x="10988640" y="905040"/>
            <a:ext cx="971640" cy="900000"/>
          </a:xfrm>
          <a:prstGeom prst="rect">
            <a:avLst/>
          </a:prstGeom>
          <a:ln w="0">
            <a:noFill/>
          </a:ln>
        </p:spPr>
      </p:pic>
      <p:pic>
        <p:nvPicPr>
          <p:cNvPr id="154" name="Picture 235" descr=""/>
          <p:cNvPicPr/>
          <p:nvPr/>
        </p:nvPicPr>
        <p:blipFill>
          <a:blip r:embed="rId54"/>
          <a:stretch/>
        </p:blipFill>
        <p:spPr>
          <a:xfrm>
            <a:off x="8140680" y="890640"/>
            <a:ext cx="900000" cy="900000"/>
          </a:xfrm>
          <a:prstGeom prst="rect">
            <a:avLst/>
          </a:prstGeom>
          <a:ln w="0">
            <a:noFill/>
          </a:ln>
        </p:spPr>
      </p:pic>
      <p:pic>
        <p:nvPicPr>
          <p:cNvPr id="155" name="Picture 236" descr=""/>
          <p:cNvPicPr/>
          <p:nvPr/>
        </p:nvPicPr>
        <p:blipFill>
          <a:blip r:embed="rId55"/>
          <a:stretch/>
        </p:blipFill>
        <p:spPr>
          <a:xfrm>
            <a:off x="10012320" y="900000"/>
            <a:ext cx="900000" cy="900360"/>
          </a:xfrm>
          <a:prstGeom prst="rect">
            <a:avLst/>
          </a:prstGeom>
          <a:ln w="0">
            <a:noFill/>
          </a:ln>
        </p:spPr>
      </p:pic>
      <p:pic>
        <p:nvPicPr>
          <p:cNvPr id="156" name="Picture 237" descr=""/>
          <p:cNvPicPr/>
          <p:nvPr/>
        </p:nvPicPr>
        <p:blipFill>
          <a:blip r:embed="rId56"/>
          <a:stretch/>
        </p:blipFill>
        <p:spPr>
          <a:xfrm>
            <a:off x="10012320" y="1817640"/>
            <a:ext cx="900000" cy="900000"/>
          </a:xfrm>
          <a:prstGeom prst="rect">
            <a:avLst/>
          </a:prstGeom>
          <a:ln w="0">
            <a:noFill/>
          </a:ln>
        </p:spPr>
      </p:pic>
      <p:pic>
        <p:nvPicPr>
          <p:cNvPr id="157" name="Picture 238" descr=""/>
          <p:cNvPicPr/>
          <p:nvPr/>
        </p:nvPicPr>
        <p:blipFill>
          <a:blip r:embed="rId57"/>
          <a:stretch/>
        </p:blipFill>
        <p:spPr>
          <a:xfrm>
            <a:off x="8121600" y="1817640"/>
            <a:ext cx="900000" cy="900000"/>
          </a:xfrm>
          <a:prstGeom prst="rect">
            <a:avLst/>
          </a:prstGeom>
          <a:ln w="0">
            <a:noFill/>
          </a:ln>
        </p:spPr>
      </p:pic>
      <p:pic>
        <p:nvPicPr>
          <p:cNvPr id="158" name="Picture 239" descr=""/>
          <p:cNvPicPr/>
          <p:nvPr/>
        </p:nvPicPr>
        <p:blipFill>
          <a:blip r:embed="rId58"/>
          <a:stretch/>
        </p:blipFill>
        <p:spPr>
          <a:xfrm>
            <a:off x="8193240" y="2889360"/>
            <a:ext cx="900000" cy="900000"/>
          </a:xfrm>
          <a:prstGeom prst="rect">
            <a:avLst/>
          </a:prstGeom>
          <a:ln w="0">
            <a:noFill/>
          </a:ln>
        </p:spPr>
      </p:pic>
      <p:pic>
        <p:nvPicPr>
          <p:cNvPr id="159" name="Picture 240" descr=""/>
          <p:cNvPicPr/>
          <p:nvPr/>
        </p:nvPicPr>
        <p:blipFill>
          <a:blip r:embed="rId59"/>
          <a:stretch/>
        </p:blipFill>
        <p:spPr>
          <a:xfrm>
            <a:off x="9126360" y="2889360"/>
            <a:ext cx="900360" cy="900000"/>
          </a:xfrm>
          <a:prstGeom prst="rect">
            <a:avLst/>
          </a:prstGeom>
          <a:ln w="0">
            <a:noFill/>
          </a:ln>
        </p:spPr>
      </p:pic>
      <p:pic>
        <p:nvPicPr>
          <p:cNvPr id="160" name="Picture 241" descr=""/>
          <p:cNvPicPr/>
          <p:nvPr/>
        </p:nvPicPr>
        <p:blipFill>
          <a:blip r:embed="rId60"/>
          <a:stretch/>
        </p:blipFill>
        <p:spPr>
          <a:xfrm>
            <a:off x="10093320" y="2889360"/>
            <a:ext cx="900000" cy="900000"/>
          </a:xfrm>
          <a:prstGeom prst="rect">
            <a:avLst/>
          </a:prstGeom>
          <a:ln w="0">
            <a:noFill/>
          </a:ln>
        </p:spPr>
      </p:pic>
      <p:pic>
        <p:nvPicPr>
          <p:cNvPr id="161" name="Picture 242" descr=""/>
          <p:cNvPicPr/>
          <p:nvPr/>
        </p:nvPicPr>
        <p:blipFill>
          <a:blip r:embed="rId61"/>
          <a:stretch/>
        </p:blipFill>
        <p:spPr>
          <a:xfrm>
            <a:off x="11050560" y="2889360"/>
            <a:ext cx="900000" cy="900000"/>
          </a:xfrm>
          <a:prstGeom prst="rect">
            <a:avLst/>
          </a:prstGeom>
          <a:ln w="0">
            <a:noFill/>
          </a:ln>
        </p:spPr>
      </p:pic>
      <p:pic>
        <p:nvPicPr>
          <p:cNvPr id="162" name="Picture 243" descr=""/>
          <p:cNvPicPr/>
          <p:nvPr/>
        </p:nvPicPr>
        <p:blipFill>
          <a:blip r:embed="rId62"/>
          <a:stretch/>
        </p:blipFill>
        <p:spPr>
          <a:xfrm>
            <a:off x="7245360" y="2870280"/>
            <a:ext cx="900000" cy="900000"/>
          </a:xfrm>
          <a:prstGeom prst="rect">
            <a:avLst/>
          </a:prstGeom>
          <a:ln w="0">
            <a:noFill/>
          </a:ln>
        </p:spPr>
      </p:pic>
      <p:pic>
        <p:nvPicPr>
          <p:cNvPr id="163" name="Picture 244" descr=""/>
          <p:cNvPicPr/>
          <p:nvPr/>
        </p:nvPicPr>
        <p:blipFill>
          <a:blip r:embed="rId63"/>
          <a:stretch/>
        </p:blipFill>
        <p:spPr>
          <a:xfrm>
            <a:off x="11026800" y="3860640"/>
            <a:ext cx="952560" cy="952560"/>
          </a:xfrm>
          <a:prstGeom prst="rect">
            <a:avLst/>
          </a:prstGeom>
          <a:ln w="0">
            <a:noFill/>
          </a:ln>
        </p:spPr>
      </p:pic>
      <p:pic>
        <p:nvPicPr>
          <p:cNvPr id="164" name="Picture 245" descr=""/>
          <p:cNvPicPr/>
          <p:nvPr/>
        </p:nvPicPr>
        <p:blipFill>
          <a:blip r:embed="rId64"/>
          <a:stretch/>
        </p:blipFill>
        <p:spPr>
          <a:xfrm>
            <a:off x="10077480" y="3867120"/>
            <a:ext cx="930240" cy="930240"/>
          </a:xfrm>
          <a:prstGeom prst="rect">
            <a:avLst/>
          </a:prstGeom>
          <a:ln w="0">
            <a:noFill/>
          </a:ln>
        </p:spPr>
      </p:pic>
      <p:pic>
        <p:nvPicPr>
          <p:cNvPr id="165" name="Picture 246" descr=""/>
          <p:cNvPicPr/>
          <p:nvPr/>
        </p:nvPicPr>
        <p:blipFill>
          <a:blip r:embed="rId65"/>
          <a:stretch/>
        </p:blipFill>
        <p:spPr>
          <a:xfrm>
            <a:off x="9134640" y="3909960"/>
            <a:ext cx="900000" cy="901800"/>
          </a:xfrm>
          <a:prstGeom prst="rect">
            <a:avLst/>
          </a:prstGeom>
          <a:ln w="0">
            <a:noFill/>
          </a:ln>
        </p:spPr>
      </p:pic>
      <p:pic>
        <p:nvPicPr>
          <p:cNvPr id="166" name="Picture 247" descr=""/>
          <p:cNvPicPr/>
          <p:nvPr/>
        </p:nvPicPr>
        <p:blipFill>
          <a:blip r:embed="rId66"/>
          <a:stretch/>
        </p:blipFill>
        <p:spPr>
          <a:xfrm>
            <a:off x="8210520" y="3924360"/>
            <a:ext cx="900000" cy="900000"/>
          </a:xfrm>
          <a:prstGeom prst="rect">
            <a:avLst/>
          </a:prstGeom>
          <a:ln w="0">
            <a:noFill/>
          </a:ln>
        </p:spPr>
      </p:pic>
      <p:pic>
        <p:nvPicPr>
          <p:cNvPr id="167" name="Picture 248" descr=""/>
          <p:cNvPicPr/>
          <p:nvPr/>
        </p:nvPicPr>
        <p:blipFill>
          <a:blip r:embed="rId67"/>
          <a:stretch/>
        </p:blipFill>
        <p:spPr>
          <a:xfrm>
            <a:off x="7242120" y="3914640"/>
            <a:ext cx="900000" cy="900360"/>
          </a:xfrm>
          <a:prstGeom prst="rect">
            <a:avLst/>
          </a:prstGeom>
          <a:ln w="0">
            <a:noFill/>
          </a:ln>
        </p:spPr>
      </p:pic>
      <p:pic>
        <p:nvPicPr>
          <p:cNvPr id="168" name="Picture 249" descr=""/>
          <p:cNvPicPr/>
          <p:nvPr/>
        </p:nvPicPr>
        <p:blipFill>
          <a:blip r:embed="rId68"/>
          <a:stretch/>
        </p:blipFill>
        <p:spPr>
          <a:xfrm>
            <a:off x="11103120" y="5099040"/>
            <a:ext cx="900000" cy="900000"/>
          </a:xfrm>
          <a:prstGeom prst="rect">
            <a:avLst/>
          </a:prstGeom>
          <a:ln w="0">
            <a:noFill/>
          </a:ln>
        </p:spPr>
      </p:pic>
      <p:pic>
        <p:nvPicPr>
          <p:cNvPr id="169" name="Picture 250" descr=""/>
          <p:cNvPicPr/>
          <p:nvPr/>
        </p:nvPicPr>
        <p:blipFill>
          <a:blip r:embed="rId69"/>
          <a:stretch/>
        </p:blipFill>
        <p:spPr>
          <a:xfrm>
            <a:off x="9112320" y="5089680"/>
            <a:ext cx="900000" cy="900000"/>
          </a:xfrm>
          <a:prstGeom prst="rect">
            <a:avLst/>
          </a:prstGeom>
          <a:ln w="0">
            <a:noFill/>
          </a:ln>
        </p:spPr>
      </p:pic>
      <p:pic>
        <p:nvPicPr>
          <p:cNvPr id="170" name="Picture 251" descr=""/>
          <p:cNvPicPr/>
          <p:nvPr/>
        </p:nvPicPr>
        <p:blipFill>
          <a:blip r:embed="rId70"/>
          <a:stretch/>
        </p:blipFill>
        <p:spPr>
          <a:xfrm>
            <a:off x="10112400" y="5079960"/>
            <a:ext cx="900000" cy="900000"/>
          </a:xfrm>
          <a:prstGeom prst="rect">
            <a:avLst/>
          </a:prstGeom>
          <a:ln w="0">
            <a:noFill/>
          </a:ln>
        </p:spPr>
      </p:pic>
      <p:pic>
        <p:nvPicPr>
          <p:cNvPr id="171" name="Picture 252" descr=""/>
          <p:cNvPicPr/>
          <p:nvPr/>
        </p:nvPicPr>
        <p:blipFill>
          <a:blip r:embed="rId71"/>
          <a:stretch/>
        </p:blipFill>
        <p:spPr>
          <a:xfrm>
            <a:off x="8183520" y="5089680"/>
            <a:ext cx="900000" cy="900000"/>
          </a:xfrm>
          <a:prstGeom prst="rect">
            <a:avLst/>
          </a:prstGeom>
          <a:ln w="0">
            <a:noFill/>
          </a:ln>
        </p:spPr>
      </p:pic>
      <p:pic>
        <p:nvPicPr>
          <p:cNvPr id="172" name="Picture 253" descr=""/>
          <p:cNvPicPr/>
          <p:nvPr/>
        </p:nvPicPr>
        <p:blipFill>
          <a:blip r:embed="rId72"/>
          <a:stretch/>
        </p:blipFill>
        <p:spPr>
          <a:xfrm>
            <a:off x="7230960" y="5084640"/>
            <a:ext cx="900360" cy="900360"/>
          </a:xfrm>
          <a:prstGeom prst="rect">
            <a:avLst/>
          </a:prstGeom>
          <a:ln w="0">
            <a:noFill/>
          </a:ln>
        </p:spPr>
      </p:pic>
      <p:pic>
        <p:nvPicPr>
          <p:cNvPr id="173" name="Picture 254" descr=""/>
          <p:cNvPicPr/>
          <p:nvPr/>
        </p:nvPicPr>
        <p:blipFill>
          <a:blip r:embed="rId73"/>
          <a:stretch/>
        </p:blipFill>
        <p:spPr>
          <a:xfrm>
            <a:off x="7207200" y="6068880"/>
            <a:ext cx="949320" cy="949320"/>
          </a:xfrm>
          <a:prstGeom prst="rect">
            <a:avLst/>
          </a:prstGeom>
          <a:ln w="0">
            <a:noFill/>
          </a:ln>
        </p:spPr>
      </p:pic>
      <p:pic>
        <p:nvPicPr>
          <p:cNvPr id="174" name="Picture 255" descr=""/>
          <p:cNvPicPr/>
          <p:nvPr/>
        </p:nvPicPr>
        <p:blipFill>
          <a:blip r:embed="rId74"/>
          <a:stretch/>
        </p:blipFill>
        <p:spPr>
          <a:xfrm>
            <a:off x="11085480" y="6070680"/>
            <a:ext cx="922320" cy="922320"/>
          </a:xfrm>
          <a:prstGeom prst="rect">
            <a:avLst/>
          </a:prstGeom>
          <a:ln w="0">
            <a:noFill/>
          </a:ln>
        </p:spPr>
      </p:pic>
      <p:pic>
        <p:nvPicPr>
          <p:cNvPr id="175" name="Picture 256" descr=""/>
          <p:cNvPicPr/>
          <p:nvPr/>
        </p:nvPicPr>
        <p:blipFill>
          <a:blip r:embed="rId75"/>
          <a:stretch/>
        </p:blipFill>
        <p:spPr>
          <a:xfrm>
            <a:off x="10093320" y="6070680"/>
            <a:ext cx="925560" cy="925560"/>
          </a:xfrm>
          <a:prstGeom prst="rect">
            <a:avLst/>
          </a:prstGeom>
          <a:ln w="0">
            <a:noFill/>
          </a:ln>
        </p:spPr>
      </p:pic>
      <p:pic>
        <p:nvPicPr>
          <p:cNvPr id="176" name="Picture 257" descr=""/>
          <p:cNvPicPr/>
          <p:nvPr/>
        </p:nvPicPr>
        <p:blipFill>
          <a:blip r:embed="rId76"/>
          <a:stretch/>
        </p:blipFill>
        <p:spPr>
          <a:xfrm>
            <a:off x="9093240" y="6053040"/>
            <a:ext cx="966600" cy="966960"/>
          </a:xfrm>
          <a:prstGeom prst="rect">
            <a:avLst/>
          </a:prstGeom>
          <a:ln w="0">
            <a:noFill/>
          </a:ln>
        </p:spPr>
      </p:pic>
      <p:pic>
        <p:nvPicPr>
          <p:cNvPr id="177" name="Picture 258" descr=""/>
          <p:cNvPicPr/>
          <p:nvPr/>
        </p:nvPicPr>
        <p:blipFill>
          <a:blip r:embed="rId77"/>
          <a:stretch/>
        </p:blipFill>
        <p:spPr>
          <a:xfrm>
            <a:off x="8177040" y="6094440"/>
            <a:ext cx="900360" cy="898560"/>
          </a:xfrm>
          <a:prstGeom prst="rect">
            <a:avLst/>
          </a:prstGeom>
          <a:ln w="0">
            <a:noFill/>
          </a:ln>
        </p:spPr>
      </p:pic>
      <p:pic>
        <p:nvPicPr>
          <p:cNvPr id="178" name="Picture 225" descr=""/>
          <p:cNvPicPr/>
          <p:nvPr/>
        </p:nvPicPr>
        <p:blipFill>
          <a:blip r:embed="rId78"/>
          <a:stretch/>
        </p:blipFill>
        <p:spPr>
          <a:xfrm>
            <a:off x="5640480" y="8153280"/>
            <a:ext cx="976320" cy="900360"/>
          </a:xfrm>
          <a:prstGeom prst="rect">
            <a:avLst/>
          </a:prstGeom>
          <a:ln w="0">
            <a:noFill/>
          </a:ln>
        </p:spPr>
      </p:pic>
      <p:sp>
        <p:nvSpPr>
          <p:cNvPr id="179" name="Text Box 15"/>
          <p:cNvSpPr/>
          <p:nvPr/>
        </p:nvSpPr>
        <p:spPr>
          <a:xfrm>
            <a:off x="6513480" y="2668680"/>
            <a:ext cx="101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1036800"/>
                <a:tab algn="l" pos="2073240"/>
                <a:tab algn="l" pos="3110040"/>
                <a:tab algn="l" pos="4146480"/>
                <a:tab algn="l" pos="5183280"/>
                <a:tab algn="l" pos="6219720"/>
                <a:tab algn="l" pos="7256520"/>
                <a:tab algn="l" pos="8292960"/>
                <a:tab algn="l" pos="9329760"/>
                <a:tab algn="l" pos="10366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Y294002   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0" name="Text Box 26"/>
          <p:cNvSpPr/>
          <p:nvPr/>
        </p:nvSpPr>
        <p:spPr>
          <a:xfrm>
            <a:off x="7191360" y="2673360"/>
            <a:ext cx="101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1036800"/>
                <a:tab algn="l" pos="2073240"/>
                <a:tab algn="l" pos="3110040"/>
                <a:tab algn="l" pos="4146480"/>
                <a:tab algn="l" pos="5183280"/>
                <a:tab algn="l" pos="6219720"/>
                <a:tab algn="l" pos="7256520"/>
                <a:tab algn="l" pos="8292960"/>
                <a:tab algn="l" pos="9329760"/>
                <a:tab algn="l" pos="10366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Vehicl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205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9-14T13:40:16Z</dcterms:created>
  <dc:creator>三文鱼水木年华</dc:creator>
  <dc:description/>
  <dc:language>en-US</dc:language>
  <cp:lastModifiedBy>三文鱼水木年华</cp:lastModifiedBy>
  <cp:lastPrinted>2015-11-24T02:45:38Z</cp:lastPrinted>
  <dcterms:modified xsi:type="dcterms:W3CDTF">2016-01-25T10:56:54Z</dcterms:modified>
  <cp:revision>215</cp:revision>
  <dc:subject/>
  <dc:title>PowerPoint 演示文稿</dc:title>
</cp:coreProperties>
</file>